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drawings/drawing4.xml" ContentType="application/vnd.openxmlformats-officedocument.drawingml.chartshap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drawings/drawing2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drawings/drawing9.xml" ContentType="application/vnd.openxmlformats-officedocument.drawingml.chartshapes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7.xml" ContentType="application/vnd.openxmlformats-officedocument.drawingml.chartshapes+xml"/>
  <Override PartName="/ppt/drawings/drawing8.xml" ContentType="application/vnd.openxmlformats-officedocument.drawingml.chartshapes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5.xml" ContentType="application/vnd.openxmlformats-officedocument.drawingml.chartshapes+xml"/>
  <Override PartName="/ppt/drawings/drawing6.xml" ContentType="application/vnd.openxmlformats-officedocument.drawingml.chartshapes+xml"/>
  <Override PartName="/ppt/drawings/drawing10.xml" ContentType="application/vnd.openxmlformats-officedocument.drawingml.chartshapes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drawings/drawing3.xml" ContentType="application/vnd.openxmlformats-officedocument.drawingml.chartshap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3" r:id="rId5"/>
    <p:sldId id="260" r:id="rId6"/>
    <p:sldId id="261" r:id="rId7"/>
    <p:sldId id="262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14" y="-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My_papers\EvaluationMethods_BMCBioinformatics\Figures\Revisions\SupplementaryFigure1_MetaSimHC_250_noCE.xlsx" TargetMode="Externa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D:\Dropbox\My_papers\EvaluationMethods_BMCBioinformatics\Figures\Figure6_FW_inSilico_vs_inVitro.xlsx" TargetMode="Externa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D:\Dropbox\My_papers\EvaluationMethods_BMCBioinformatics\Figures\Revisions\SupplementaryFigure6_ComputationalCost.xlsx" TargetMode="Externa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oleObject" Target="file:///D:\Dropbox\My_papers\EvaluationMethods_BMCBioinformatics\Figures\Revisions\SupplementaryFigure6_ComputationalCos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Dropbox\My_papers\EvaluationMethods_BMCBioinformatics\Figures\Revisions\SupplementaryFigure1_MetaSimHC_250_noCE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Dropbox\My_papers\EvaluationMethods_BMCBioinformatics\Figures\Revisions\SupplementaryFigure3_MetaSimHC_250_CE_taxonomic_distance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D:\Dropbox\My_papers\EvaluationMethods_BMCBioinformatics\Figures\Revisions\Supplementary_Figure_S4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D:\Dropbox\My_papers\EvaluationMethods_BMCBioinformatics\Figures\Revisions\Supplementary_Figure_S4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D:\Dropbox\My_papers\EvaluationMethods_BMCBioinformatics\Figures\Revisions\SupplementaryFigure4_GenusMetaSimHC_Lengths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D:\Dropbox\My_papers\EvaluationMethods_BMCBioinformatics\Figures\Revisions\SupplementaryFigure4_GenusMetaSimHC_Lengths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D:\Dropbox\My_papers\EvaluationMethods_BMCBioinformatics\Figures\Revisions\SupplementaryFigure4_GenusMetaSimHC_Lengths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D:\Dropbox\My_papers\EvaluationMethods_BMCBioinformatics\Figures\Figure6_FW_inSilico_vs_inVitr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3"/>
  <c:chart>
    <c:plotArea>
      <c:layout/>
      <c:barChart>
        <c:barDir val="col"/>
        <c:grouping val="clustered"/>
        <c:ser>
          <c:idx val="0"/>
          <c:order val="0"/>
          <c:tx>
            <c:strRef>
              <c:f>'250_nothing'!$B$2</c:f>
              <c:strCache>
                <c:ptCount val="1"/>
                <c:pt idx="0">
                  <c:v>Sensitivity</c:v>
                </c:pt>
              </c:strCache>
            </c:strRef>
          </c:tx>
          <c:cat>
            <c:strRef>
              <c:f>'250_nothing'!$A$3:$A$19</c:f>
              <c:strCache>
                <c:ptCount val="17"/>
                <c:pt idx="0">
                  <c:v>CARMA3</c:v>
                </c:pt>
                <c:pt idx="1">
                  <c:v>CLARK</c:v>
                </c:pt>
                <c:pt idx="2">
                  <c:v>DiScRIBinATE BLASTX</c:v>
                </c:pt>
                <c:pt idx="3">
                  <c:v>DiScRIBinATE RAPSearch2</c:v>
                </c:pt>
                <c:pt idx="4">
                  <c:v>Kraken</c:v>
                </c:pt>
                <c:pt idx="5">
                  <c:v>Filtered Kraken</c:v>
                </c:pt>
                <c:pt idx="6">
                  <c:v>MEGAN4 BLASTN</c:v>
                </c:pt>
                <c:pt idx="7">
                  <c:v>MEGAN4 BLASTX</c:v>
                </c:pt>
                <c:pt idx="8">
                  <c:v>MEGAN4 RAPSearch2</c:v>
                </c:pt>
                <c:pt idx="9">
                  <c:v>MetaBin</c:v>
                </c:pt>
                <c:pt idx="10">
                  <c:v>MetaCV</c:v>
                </c:pt>
                <c:pt idx="11">
                  <c:v>MetaPhyler</c:v>
                </c:pt>
                <c:pt idx="12">
                  <c:v>PhymmBL</c:v>
                </c:pt>
                <c:pt idx="13">
                  <c:v>RITA</c:v>
                </c:pt>
                <c:pt idx="14">
                  <c:v>TACOA</c:v>
                </c:pt>
                <c:pt idx="15">
                  <c:v>MG-RAST best hit</c:v>
                </c:pt>
                <c:pt idx="16">
                  <c:v>MG-RAST LCA</c:v>
                </c:pt>
              </c:strCache>
            </c:strRef>
          </c:cat>
          <c:val>
            <c:numRef>
              <c:f>'250_nothing'!$B$3:$B$19</c:f>
              <c:numCache>
                <c:formatCode>General</c:formatCode>
                <c:ptCount val="17"/>
                <c:pt idx="0">
                  <c:v>0.91206461274491502</c:v>
                </c:pt>
                <c:pt idx="1">
                  <c:v>0.97925407636284112</c:v>
                </c:pt>
                <c:pt idx="2">
                  <c:v>0.91497090695837613</c:v>
                </c:pt>
                <c:pt idx="3">
                  <c:v>0.9549708644300331</c:v>
                </c:pt>
                <c:pt idx="4">
                  <c:v>1</c:v>
                </c:pt>
                <c:pt idx="5">
                  <c:v>1</c:v>
                </c:pt>
                <c:pt idx="6">
                  <c:v>0.95611229566453404</c:v>
                </c:pt>
                <c:pt idx="7">
                  <c:v>0.96986765783389406</c:v>
                </c:pt>
                <c:pt idx="8">
                  <c:v>0.94851783014157909</c:v>
                </c:pt>
                <c:pt idx="9">
                  <c:v>0.87095971800748406</c:v>
                </c:pt>
                <c:pt idx="10">
                  <c:v>0.95822160165368819</c:v>
                </c:pt>
                <c:pt idx="11">
                  <c:v>5.762425823622061E-3</c:v>
                </c:pt>
                <c:pt idx="12">
                  <c:v>0.91737488506412002</c:v>
                </c:pt>
                <c:pt idx="13">
                  <c:v>0.82649717383256893</c:v>
                </c:pt>
                <c:pt idx="14">
                  <c:v>0.53024111473721691</c:v>
                </c:pt>
                <c:pt idx="15">
                  <c:v>0.75826171975505596</c:v>
                </c:pt>
                <c:pt idx="16">
                  <c:v>0.76833878853165394</c:v>
                </c:pt>
              </c:numCache>
            </c:numRef>
          </c:val>
        </c:ser>
        <c:ser>
          <c:idx val="1"/>
          <c:order val="1"/>
          <c:tx>
            <c:strRef>
              <c:f>'250_nothing'!$C$2</c:f>
              <c:strCache>
                <c:ptCount val="1"/>
                <c:pt idx="0">
                  <c:v>Precision</c:v>
                </c:pt>
              </c:strCache>
            </c:strRef>
          </c:tx>
          <c:cat>
            <c:strRef>
              <c:f>'250_nothing'!$A$3:$A$19</c:f>
              <c:strCache>
                <c:ptCount val="17"/>
                <c:pt idx="0">
                  <c:v>CARMA3</c:v>
                </c:pt>
                <c:pt idx="1">
                  <c:v>CLARK</c:v>
                </c:pt>
                <c:pt idx="2">
                  <c:v>DiScRIBinATE BLASTX</c:v>
                </c:pt>
                <c:pt idx="3">
                  <c:v>DiScRIBinATE RAPSearch2</c:v>
                </c:pt>
                <c:pt idx="4">
                  <c:v>Kraken</c:v>
                </c:pt>
                <c:pt idx="5">
                  <c:v>Filtered Kraken</c:v>
                </c:pt>
                <c:pt idx="6">
                  <c:v>MEGAN4 BLASTN</c:v>
                </c:pt>
                <c:pt idx="7">
                  <c:v>MEGAN4 BLASTX</c:v>
                </c:pt>
                <c:pt idx="8">
                  <c:v>MEGAN4 RAPSearch2</c:v>
                </c:pt>
                <c:pt idx="9">
                  <c:v>MetaBin</c:v>
                </c:pt>
                <c:pt idx="10">
                  <c:v>MetaCV</c:v>
                </c:pt>
                <c:pt idx="11">
                  <c:v>MetaPhyler</c:v>
                </c:pt>
                <c:pt idx="12">
                  <c:v>PhymmBL</c:v>
                </c:pt>
                <c:pt idx="13">
                  <c:v>RITA</c:v>
                </c:pt>
                <c:pt idx="14">
                  <c:v>TACOA</c:v>
                </c:pt>
                <c:pt idx="15">
                  <c:v>MG-RAST best hit</c:v>
                </c:pt>
                <c:pt idx="16">
                  <c:v>MG-RAST LCA</c:v>
                </c:pt>
              </c:strCache>
            </c:strRef>
          </c:cat>
          <c:val>
            <c:numRef>
              <c:f>'250_nothing'!$C$3:$C$19</c:f>
              <c:numCache>
                <c:formatCode>General</c:formatCode>
                <c:ptCount val="17"/>
                <c:pt idx="0">
                  <c:v>0.98091513869182401</c:v>
                </c:pt>
                <c:pt idx="1">
                  <c:v>0.99489908095510304</c:v>
                </c:pt>
                <c:pt idx="2">
                  <c:v>0.98842336227248984</c:v>
                </c:pt>
                <c:pt idx="3">
                  <c:v>0.99462282039789895</c:v>
                </c:pt>
                <c:pt idx="4">
                  <c:v>1</c:v>
                </c:pt>
                <c:pt idx="5">
                  <c:v>1</c:v>
                </c:pt>
                <c:pt idx="6">
                  <c:v>0.95611229566453404</c:v>
                </c:pt>
                <c:pt idx="7">
                  <c:v>0.98607100731735797</c:v>
                </c:pt>
                <c:pt idx="8">
                  <c:v>0.98725771339751001</c:v>
                </c:pt>
                <c:pt idx="9">
                  <c:v>0.90973234075428488</c:v>
                </c:pt>
                <c:pt idx="10">
                  <c:v>0.95945946425613304</c:v>
                </c:pt>
                <c:pt idx="11">
                  <c:v>0.95184588621867117</c:v>
                </c:pt>
                <c:pt idx="12">
                  <c:v>0.91862080039949423</c:v>
                </c:pt>
                <c:pt idx="13">
                  <c:v>0.99846817146091182</c:v>
                </c:pt>
                <c:pt idx="14">
                  <c:v>0.70924717454784103</c:v>
                </c:pt>
                <c:pt idx="15">
                  <c:v>0.75826171975505596</c:v>
                </c:pt>
                <c:pt idx="16">
                  <c:v>0.88289344481804399</c:v>
                </c:pt>
              </c:numCache>
            </c:numRef>
          </c:val>
        </c:ser>
        <c:dLbls/>
        <c:axId val="105482112"/>
        <c:axId val="105483648"/>
      </c:barChart>
      <c:catAx>
        <c:axId val="105482112"/>
        <c:scaling>
          <c:orientation val="minMax"/>
        </c:scaling>
        <c:axPos val="b"/>
        <c:tickLblPos val="low"/>
        <c:txPr>
          <a:bodyPr/>
          <a:lstStyle/>
          <a:p>
            <a:pPr>
              <a:defRPr sz="1000"/>
            </a:pPr>
            <a:endParaRPr lang="en-US"/>
          </a:p>
        </c:txPr>
        <c:crossAx val="105483648"/>
        <c:crosses val="autoZero"/>
        <c:auto val="1"/>
        <c:lblAlgn val="ctr"/>
        <c:lblOffset val="20"/>
      </c:catAx>
      <c:valAx>
        <c:axId val="105483648"/>
        <c:scaling>
          <c:orientation val="minMax"/>
          <c:max val="1"/>
        </c:scaling>
        <c:axPos val="l"/>
        <c:numFmt formatCode="General" sourceLinked="1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05482112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3"/>
  <c:chart>
    <c:plotArea>
      <c:layout/>
      <c:barChart>
        <c:barDir val="col"/>
        <c:grouping val="clustered"/>
        <c:ser>
          <c:idx val="0"/>
          <c:order val="0"/>
          <c:tx>
            <c:strRef>
              <c:f>InVitro_Community!$E$3</c:f>
              <c:strCache>
                <c:ptCount val="1"/>
                <c:pt idx="0">
                  <c:v>In silico</c:v>
                </c:pt>
              </c:strCache>
            </c:strRef>
          </c:tx>
          <c:cat>
            <c:strRef>
              <c:f>InVitro_Community!$D$4:$D$15</c:f>
              <c:strCache>
                <c:ptCount val="12"/>
                <c:pt idx="0">
                  <c:v>CARMA3</c:v>
                </c:pt>
                <c:pt idx="1">
                  <c:v>DiScRIBinATE RAPSearch2</c:v>
                </c:pt>
                <c:pt idx="2">
                  <c:v>Kraken</c:v>
                </c:pt>
                <c:pt idx="3">
                  <c:v>Filtered Kraken</c:v>
                </c:pt>
                <c:pt idx="4">
                  <c:v>MEGAN4 BLASTN</c:v>
                </c:pt>
                <c:pt idx="5">
                  <c:v>MEGAN4 RAPSearch2</c:v>
                </c:pt>
                <c:pt idx="6">
                  <c:v>MetaBin</c:v>
                </c:pt>
                <c:pt idx="7">
                  <c:v>MetaCV</c:v>
                </c:pt>
                <c:pt idx="8">
                  <c:v>MetaPhyler</c:v>
                </c:pt>
                <c:pt idx="9">
                  <c:v>PhymmBL</c:v>
                </c:pt>
                <c:pt idx="10">
                  <c:v>RITA</c:v>
                </c:pt>
                <c:pt idx="11">
                  <c:v>TACOA</c:v>
                </c:pt>
              </c:strCache>
            </c:strRef>
          </c:cat>
          <c:val>
            <c:numRef>
              <c:f>InVitro_Community!$E$4:$E$15</c:f>
              <c:numCache>
                <c:formatCode>General</c:formatCode>
                <c:ptCount val="12"/>
                <c:pt idx="0">
                  <c:v>0.99512873539073299</c:v>
                </c:pt>
                <c:pt idx="1">
                  <c:v>0.99633859297358618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0.98661734873184859</c:v>
                </c:pt>
                <c:pt idx="6">
                  <c:v>0.97754428513856495</c:v>
                </c:pt>
                <c:pt idx="7">
                  <c:v>0.96532463726127626</c:v>
                </c:pt>
                <c:pt idx="8">
                  <c:v>0.87916343919442319</c:v>
                </c:pt>
                <c:pt idx="9">
                  <c:v>0.84856245469920299</c:v>
                </c:pt>
                <c:pt idx="10">
                  <c:v>0.99136463652592699</c:v>
                </c:pt>
                <c:pt idx="11">
                  <c:v>0.8144167902399565</c:v>
                </c:pt>
              </c:numCache>
            </c:numRef>
          </c:val>
        </c:ser>
        <c:ser>
          <c:idx val="1"/>
          <c:order val="1"/>
          <c:tx>
            <c:strRef>
              <c:f>InVitro_Community!$F$3</c:f>
              <c:strCache>
                <c:ptCount val="1"/>
                <c:pt idx="0">
                  <c:v>In vitro</c:v>
                </c:pt>
              </c:strCache>
            </c:strRef>
          </c:tx>
          <c:cat>
            <c:strRef>
              <c:f>InVitro_Community!$D$4:$D$15</c:f>
              <c:strCache>
                <c:ptCount val="12"/>
                <c:pt idx="0">
                  <c:v>CARMA3</c:v>
                </c:pt>
                <c:pt idx="1">
                  <c:v>DiScRIBinATE RAPSearch2</c:v>
                </c:pt>
                <c:pt idx="2">
                  <c:v>Kraken</c:v>
                </c:pt>
                <c:pt idx="3">
                  <c:v>Filtered Kraken</c:v>
                </c:pt>
                <c:pt idx="4">
                  <c:v>MEGAN4 BLASTN</c:v>
                </c:pt>
                <c:pt idx="5">
                  <c:v>MEGAN4 RAPSearch2</c:v>
                </c:pt>
                <c:pt idx="6">
                  <c:v>MetaBin</c:v>
                </c:pt>
                <c:pt idx="7">
                  <c:v>MetaCV</c:v>
                </c:pt>
                <c:pt idx="8">
                  <c:v>MetaPhyler</c:v>
                </c:pt>
                <c:pt idx="9">
                  <c:v>PhymmBL</c:v>
                </c:pt>
                <c:pt idx="10">
                  <c:v>RITA</c:v>
                </c:pt>
                <c:pt idx="11">
                  <c:v>TACOA</c:v>
                </c:pt>
              </c:strCache>
            </c:strRef>
          </c:cat>
          <c:val>
            <c:numRef>
              <c:f>InVitro_Community!$F$4:$F$15</c:f>
              <c:numCache>
                <c:formatCode>General</c:formatCode>
                <c:ptCount val="12"/>
                <c:pt idx="0">
                  <c:v>0.94606830468990399</c:v>
                </c:pt>
                <c:pt idx="1">
                  <c:v>0.95340975007384321</c:v>
                </c:pt>
                <c:pt idx="2">
                  <c:v>0.97623250513206761</c:v>
                </c:pt>
                <c:pt idx="3">
                  <c:v>0.99888587785838523</c:v>
                </c:pt>
                <c:pt idx="4">
                  <c:v>0.97325985055014042</c:v>
                </c:pt>
                <c:pt idx="5">
                  <c:v>0.95219075707965695</c:v>
                </c:pt>
                <c:pt idx="6">
                  <c:v>0.94226413148259103</c:v>
                </c:pt>
                <c:pt idx="7">
                  <c:v>0.88546042863705676</c:v>
                </c:pt>
                <c:pt idx="8">
                  <c:v>0.86013555144793596</c:v>
                </c:pt>
                <c:pt idx="9">
                  <c:v>0.73917151573827322</c:v>
                </c:pt>
                <c:pt idx="10">
                  <c:v>0.93097647100785896</c:v>
                </c:pt>
                <c:pt idx="11">
                  <c:v>0.83038282125025076</c:v>
                </c:pt>
              </c:numCache>
            </c:numRef>
          </c:val>
        </c:ser>
        <c:dLbls/>
        <c:axId val="108779392"/>
        <c:axId val="108780928"/>
      </c:barChart>
      <c:catAx>
        <c:axId val="108779392"/>
        <c:scaling>
          <c:orientation val="minMax"/>
        </c:scaling>
        <c:axPos val="b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08780928"/>
        <c:crosses val="autoZero"/>
        <c:auto val="1"/>
        <c:lblAlgn val="ctr"/>
        <c:lblOffset val="100"/>
      </c:catAx>
      <c:valAx>
        <c:axId val="108780928"/>
        <c:scaling>
          <c:orientation val="minMax"/>
          <c:max val="1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Precision</a:t>
                </a:r>
              </a:p>
            </c:rich>
          </c:tx>
          <c:layout/>
        </c:title>
        <c:numFmt formatCode="General" sourceLinked="1"/>
        <c:tickLblPos val="nextTo"/>
        <c:crossAx val="108779392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sz="1100" i="1"/>
          </a:pPr>
          <a:endParaRPr lang="en-US"/>
        </a:p>
      </c:txPr>
    </c:legend>
    <c:plotVisOnly val="1"/>
    <c:dispBlanksAs val="gap"/>
  </c:chart>
  <c:externalData r:id="rId1"/>
  <c:userShapes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lineChart>
        <c:grouping val="standard"/>
        <c:ser>
          <c:idx val="0"/>
          <c:order val="0"/>
          <c:tx>
            <c:strRef>
              <c:f>'Sheet6 (2)'!$A$2</c:f>
              <c:strCache>
                <c:ptCount val="1"/>
                <c:pt idx="0">
                  <c:v>CARMA3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2,'Sheet6 (2)'!$E$2,'Sheet6 (2)'!$G$2,'Sheet6 (2)'!$I$2)</c:f>
              <c:numCache>
                <c:formatCode>General</c:formatCode>
                <c:ptCount val="4"/>
                <c:pt idx="0">
                  <c:v>2201</c:v>
                </c:pt>
                <c:pt idx="1">
                  <c:v>6004</c:v>
                </c:pt>
                <c:pt idx="2">
                  <c:v>12790</c:v>
                </c:pt>
                <c:pt idx="3">
                  <c:v>25135</c:v>
                </c:pt>
              </c:numCache>
            </c:numRef>
          </c:val>
        </c:ser>
        <c:ser>
          <c:idx val="1"/>
          <c:order val="1"/>
          <c:tx>
            <c:strRef>
              <c:f>'Sheet6 (2)'!$A$3</c:f>
              <c:strCache>
                <c:ptCount val="1"/>
                <c:pt idx="0">
                  <c:v>CLARK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3,'Sheet6 (2)'!$E$3,'Sheet6 (2)'!$G$3,'Sheet6 (2)'!$I$3)</c:f>
              <c:numCache>
                <c:formatCode>General</c:formatCode>
                <c:ptCount val="4"/>
                <c:pt idx="0">
                  <c:v>1.1000000000000001</c:v>
                </c:pt>
                <c:pt idx="1">
                  <c:v>1.1400000000000001</c:v>
                </c:pt>
                <c:pt idx="2">
                  <c:v>1.29</c:v>
                </c:pt>
                <c:pt idx="3">
                  <c:v>1.58</c:v>
                </c:pt>
              </c:numCache>
            </c:numRef>
          </c:val>
        </c:ser>
        <c:ser>
          <c:idx val="2"/>
          <c:order val="2"/>
          <c:tx>
            <c:strRef>
              <c:f>'Sheet6 (2)'!$A$4</c:f>
              <c:strCache>
                <c:ptCount val="1"/>
                <c:pt idx="0">
                  <c:v>DiScRIBinATE BLASTX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4,'Sheet6 (2)'!$E$4,'Sheet6 (2)'!$G$4,'Sheet6 (2)'!$I$4)</c:f>
              <c:numCache>
                <c:formatCode>General</c:formatCode>
                <c:ptCount val="4"/>
                <c:pt idx="0">
                  <c:v>2113</c:v>
                </c:pt>
                <c:pt idx="1">
                  <c:v>5943</c:v>
                </c:pt>
                <c:pt idx="2">
                  <c:v>12761.000000000002</c:v>
                </c:pt>
                <c:pt idx="3">
                  <c:v>25081</c:v>
                </c:pt>
              </c:numCache>
            </c:numRef>
          </c:val>
        </c:ser>
        <c:ser>
          <c:idx val="3"/>
          <c:order val="3"/>
          <c:tx>
            <c:strRef>
              <c:f>'Sheet6 (2)'!$A$5</c:f>
              <c:strCache>
                <c:ptCount val="1"/>
                <c:pt idx="0">
                  <c:v>DiScRIBinATE RAPSearch2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5,'Sheet6 (2)'!$E$5,'Sheet6 (2)'!$G$5,'Sheet6 (2)'!$I$5)</c:f>
              <c:numCache>
                <c:formatCode>General</c:formatCode>
                <c:ptCount val="4"/>
                <c:pt idx="0">
                  <c:v>35</c:v>
                </c:pt>
                <c:pt idx="1">
                  <c:v>94</c:v>
                </c:pt>
                <c:pt idx="2">
                  <c:v>206</c:v>
                </c:pt>
                <c:pt idx="3">
                  <c:v>441</c:v>
                </c:pt>
              </c:numCache>
            </c:numRef>
          </c:val>
        </c:ser>
        <c:ser>
          <c:idx val="4"/>
          <c:order val="4"/>
          <c:tx>
            <c:strRef>
              <c:f>'Sheet6 (2)'!$A$6</c:f>
              <c:strCache>
                <c:ptCount val="1"/>
                <c:pt idx="0">
                  <c:v>Kraken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6,'Sheet6 (2)'!$E$6,'Sheet6 (2)'!$G$6,'Sheet6 (2)'!$I$6)</c:f>
              <c:numCache>
                <c:formatCode>General</c:formatCode>
                <c:ptCount val="4"/>
                <c:pt idx="0">
                  <c:v>1.04</c:v>
                </c:pt>
                <c:pt idx="1">
                  <c:v>1.1000000000000001</c:v>
                </c:pt>
                <c:pt idx="2">
                  <c:v>1.25</c:v>
                </c:pt>
                <c:pt idx="3">
                  <c:v>1.5</c:v>
                </c:pt>
              </c:numCache>
            </c:numRef>
          </c:val>
        </c:ser>
        <c:ser>
          <c:idx val="5"/>
          <c:order val="5"/>
          <c:tx>
            <c:strRef>
              <c:f>'Sheet6 (2)'!$A$7</c:f>
              <c:strCache>
                <c:ptCount val="1"/>
                <c:pt idx="0">
                  <c:v>Megan4 BLASTN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7,'Sheet6 (2)'!$E$7,'Sheet6 (2)'!$G$7,'Sheet6 (2)'!$I$7)</c:f>
              <c:numCache>
                <c:formatCode>General</c:formatCode>
                <c:ptCount val="4"/>
                <c:pt idx="0">
                  <c:v>11</c:v>
                </c:pt>
                <c:pt idx="1">
                  <c:v>19</c:v>
                </c:pt>
                <c:pt idx="2">
                  <c:v>24</c:v>
                </c:pt>
                <c:pt idx="3">
                  <c:v>28</c:v>
                </c:pt>
              </c:numCache>
            </c:numRef>
          </c:val>
        </c:ser>
        <c:ser>
          <c:idx val="6"/>
          <c:order val="6"/>
          <c:tx>
            <c:strRef>
              <c:f>'Sheet6 (2)'!$A$8</c:f>
              <c:strCache>
                <c:ptCount val="1"/>
                <c:pt idx="0">
                  <c:v>Megan4 BLASTX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8,'Sheet6 (2)'!$E$8,'Sheet6 (2)'!$G$8,'Sheet6 (2)'!$I$8)</c:f>
              <c:numCache>
                <c:formatCode>General</c:formatCode>
                <c:ptCount val="4"/>
                <c:pt idx="0">
                  <c:v>2125</c:v>
                </c:pt>
                <c:pt idx="1">
                  <c:v>5950</c:v>
                </c:pt>
                <c:pt idx="2">
                  <c:v>12761.000000000002</c:v>
                </c:pt>
                <c:pt idx="3">
                  <c:v>25081</c:v>
                </c:pt>
              </c:numCache>
            </c:numRef>
          </c:val>
        </c:ser>
        <c:ser>
          <c:idx val="7"/>
          <c:order val="7"/>
          <c:tx>
            <c:strRef>
              <c:f>'Sheet6 (2)'!$A$9</c:f>
              <c:strCache>
                <c:ptCount val="1"/>
                <c:pt idx="0">
                  <c:v>Megan4 RAPSearch2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9,'Sheet6 (2)'!$E$9,'Sheet6 (2)'!$G$9,'Sheet6 (2)'!$I$9)</c:f>
              <c:numCache>
                <c:formatCode>General</c:formatCode>
                <c:ptCount val="4"/>
                <c:pt idx="0">
                  <c:v>36</c:v>
                </c:pt>
                <c:pt idx="1">
                  <c:v>95</c:v>
                </c:pt>
                <c:pt idx="2">
                  <c:v>209</c:v>
                </c:pt>
                <c:pt idx="3">
                  <c:v>444</c:v>
                </c:pt>
              </c:numCache>
            </c:numRef>
          </c:val>
        </c:ser>
        <c:ser>
          <c:idx val="8"/>
          <c:order val="8"/>
          <c:tx>
            <c:strRef>
              <c:f>'Sheet6 (2)'!$A$10</c:f>
              <c:strCache>
                <c:ptCount val="1"/>
                <c:pt idx="0">
                  <c:v>MetaBin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10,'Sheet6 (2)'!$E$10,'Sheet6 (2)'!$G$10,'Sheet6 (2)'!$I$10)</c:f>
              <c:numCache>
                <c:formatCode>General</c:formatCode>
                <c:ptCount val="4"/>
                <c:pt idx="0">
                  <c:v>2136</c:v>
                </c:pt>
                <c:pt idx="1">
                  <c:v>5941</c:v>
                </c:pt>
                <c:pt idx="2">
                  <c:v>12761.000000000002</c:v>
                </c:pt>
                <c:pt idx="3">
                  <c:v>25081</c:v>
                </c:pt>
              </c:numCache>
            </c:numRef>
          </c:val>
        </c:ser>
        <c:ser>
          <c:idx val="9"/>
          <c:order val="9"/>
          <c:tx>
            <c:strRef>
              <c:f>'Sheet6 (2)'!$A$11</c:f>
              <c:strCache>
                <c:ptCount val="1"/>
                <c:pt idx="0">
                  <c:v>MetaCV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11,'Sheet6 (2)'!$E$11,'Sheet6 (2)'!$G$11,'Sheet6 (2)'!$I$11)</c:f>
              <c:numCache>
                <c:formatCode>General</c:formatCode>
                <c:ptCount val="4"/>
                <c:pt idx="0">
                  <c:v>50</c:v>
                </c:pt>
                <c:pt idx="1">
                  <c:v>55</c:v>
                </c:pt>
                <c:pt idx="2">
                  <c:v>91</c:v>
                </c:pt>
                <c:pt idx="3">
                  <c:v>166</c:v>
                </c:pt>
              </c:numCache>
            </c:numRef>
          </c:val>
        </c:ser>
        <c:ser>
          <c:idx val="10"/>
          <c:order val="10"/>
          <c:tx>
            <c:strRef>
              <c:f>'Sheet6 (2)'!$A$12</c:f>
              <c:strCache>
                <c:ptCount val="1"/>
                <c:pt idx="0">
                  <c:v>MetaPhyler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12,'Sheet6 (2)'!$E$12,'Sheet6 (2)'!$G$12,'Sheet6 (2)'!$I$12)</c:f>
              <c:numCache>
                <c:formatCode>General</c:formatCode>
                <c:ptCount val="4"/>
                <c:pt idx="0">
                  <c:v>16</c:v>
                </c:pt>
                <c:pt idx="1">
                  <c:v>30</c:v>
                </c:pt>
                <c:pt idx="2">
                  <c:v>51</c:v>
                </c:pt>
                <c:pt idx="3">
                  <c:v>96</c:v>
                </c:pt>
              </c:numCache>
            </c:numRef>
          </c:val>
        </c:ser>
        <c:ser>
          <c:idx val="11"/>
          <c:order val="11"/>
          <c:tx>
            <c:strRef>
              <c:f>'Sheet6 (2)'!$A$13</c:f>
              <c:strCache>
                <c:ptCount val="1"/>
                <c:pt idx="0">
                  <c:v>PhymmBL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13,'Sheet6 (2)'!$E$13,'Sheet6 (2)'!$G$13,'Sheet6 (2)'!$I$13)</c:f>
              <c:numCache>
                <c:formatCode>General</c:formatCode>
                <c:ptCount val="4"/>
                <c:pt idx="0">
                  <c:v>206</c:v>
                </c:pt>
                <c:pt idx="1">
                  <c:v>421</c:v>
                </c:pt>
                <c:pt idx="2">
                  <c:v>858</c:v>
                </c:pt>
                <c:pt idx="3">
                  <c:v>1925</c:v>
                </c:pt>
              </c:numCache>
            </c:numRef>
          </c:val>
        </c:ser>
        <c:ser>
          <c:idx val="12"/>
          <c:order val="12"/>
          <c:tx>
            <c:strRef>
              <c:f>'Sheet6 (2)'!$A$14</c:f>
              <c:strCache>
                <c:ptCount val="1"/>
                <c:pt idx="0">
                  <c:v>RITA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14,'Sheet6 (2)'!$E$14,'Sheet6 (2)'!$G$14,'Sheet6 (2)'!$I$14)</c:f>
              <c:numCache>
                <c:formatCode>General</c:formatCode>
                <c:ptCount val="4"/>
                <c:pt idx="0">
                  <c:v>474</c:v>
                </c:pt>
                <c:pt idx="1">
                  <c:v>581</c:v>
                </c:pt>
                <c:pt idx="2">
                  <c:v>1265</c:v>
                </c:pt>
                <c:pt idx="3">
                  <c:v>3965</c:v>
                </c:pt>
              </c:numCache>
            </c:numRef>
          </c:val>
        </c:ser>
        <c:ser>
          <c:idx val="13"/>
          <c:order val="13"/>
          <c:tx>
            <c:strRef>
              <c:f>'Sheet6 (2)'!$A$15</c:f>
              <c:strCache>
                <c:ptCount val="1"/>
                <c:pt idx="0">
                  <c:v>TACOA</c:v>
                </c:pt>
              </c:strCache>
            </c:strRef>
          </c:tx>
          <c:marker>
            <c:symbol val="none"/>
          </c:marker>
          <c:cat>
            <c:numRef>
              <c:f>('Sheet6 (2)'!$C$1,'Sheet6 (2)'!$E$1,'Sheet6 (2)'!$G$1,'Sheet6 (2)'!$I$1)</c:f>
              <c:numCache>
                <c:formatCode>General</c:formatCode>
                <c:ptCount val="4"/>
                <c:pt idx="0">
                  <c:v>100</c:v>
                </c:pt>
                <c:pt idx="1">
                  <c:v>250</c:v>
                </c:pt>
                <c:pt idx="2">
                  <c:v>500</c:v>
                </c:pt>
                <c:pt idx="3">
                  <c:v>1000</c:v>
                </c:pt>
              </c:numCache>
            </c:numRef>
          </c:cat>
          <c:val>
            <c:numRef>
              <c:f>('Sheet6 (2)'!$C$15,'Sheet6 (2)'!$E$15,'Sheet6 (2)'!$G$15,'Sheet6 (2)'!$I$15)</c:f>
              <c:numCache>
                <c:formatCode>General</c:formatCode>
                <c:ptCount val="4"/>
                <c:pt idx="0">
                  <c:v>3971</c:v>
                </c:pt>
                <c:pt idx="1">
                  <c:v>4291</c:v>
                </c:pt>
                <c:pt idx="2">
                  <c:v>4611</c:v>
                </c:pt>
                <c:pt idx="3">
                  <c:v>5125</c:v>
                </c:pt>
              </c:numCache>
            </c:numRef>
          </c:val>
        </c:ser>
        <c:dLbls/>
        <c:marker val="1"/>
        <c:axId val="108899712"/>
        <c:axId val="108934656"/>
      </c:lineChart>
      <c:catAx>
        <c:axId val="10889971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CA" sz="1200"/>
                  <a:t>Read length (bp)</a:t>
                </a:r>
              </a:p>
            </c:rich>
          </c:tx>
        </c:title>
        <c:numFmt formatCode="General" sourceLinked="1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08934656"/>
        <c:crosses val="autoZero"/>
        <c:auto val="1"/>
        <c:lblAlgn val="ctr"/>
        <c:lblOffset val="100"/>
      </c:catAx>
      <c:valAx>
        <c:axId val="108934656"/>
        <c:scaling>
          <c:logBase val="10"/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 b="1" i="0" baseline="0">
                    <a:effectLst/>
                  </a:rPr>
                  <a:t>Running time (minutes)</a:t>
                </a:r>
                <a:endParaRPr lang="en-CA" sz="1200">
                  <a:effectLst/>
                </a:endParaRPr>
              </a:p>
            </c:rich>
          </c:tx>
        </c:title>
        <c:numFmt formatCode="General" sourceLinked="1"/>
        <c:tickLblPos val="nextTo"/>
        <c:crossAx val="108899712"/>
        <c:crosses val="autoZero"/>
        <c:crossBetween val="between"/>
      </c:valAx>
    </c:plotArea>
    <c:legend>
      <c:legendPos val="r"/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</c:chart>
  <c:externalData r:id="rId1"/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lineChart>
        <c:grouping val="standard"/>
        <c:ser>
          <c:idx val="0"/>
          <c:order val="0"/>
          <c:tx>
            <c:strRef>
              <c:f>'Sheet6 (2)'!$A$18</c:f>
              <c:strCache>
                <c:ptCount val="1"/>
                <c:pt idx="0">
                  <c:v>CARMA3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18,'Sheet6 (2)'!$E$18)</c:f>
              <c:numCache>
                <c:formatCode>General</c:formatCode>
                <c:ptCount val="2"/>
                <c:pt idx="0">
                  <c:v>6004</c:v>
                </c:pt>
                <c:pt idx="1">
                  <c:v>12982</c:v>
                </c:pt>
              </c:numCache>
            </c:numRef>
          </c:val>
        </c:ser>
        <c:ser>
          <c:idx val="1"/>
          <c:order val="1"/>
          <c:tx>
            <c:strRef>
              <c:f>'Sheet6 (2)'!$A$19</c:f>
              <c:strCache>
                <c:ptCount val="1"/>
                <c:pt idx="0">
                  <c:v>CLARK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19,'Sheet6 (2)'!$E$19)</c:f>
              <c:numCache>
                <c:formatCode>General</c:formatCode>
                <c:ptCount val="2"/>
                <c:pt idx="0">
                  <c:v>1.1400000000000001</c:v>
                </c:pt>
                <c:pt idx="1">
                  <c:v>1.25</c:v>
                </c:pt>
              </c:numCache>
            </c:numRef>
          </c:val>
        </c:ser>
        <c:ser>
          <c:idx val="2"/>
          <c:order val="2"/>
          <c:tx>
            <c:strRef>
              <c:f>'Sheet6 (2)'!$A$20</c:f>
              <c:strCache>
                <c:ptCount val="1"/>
                <c:pt idx="0">
                  <c:v>DiScRIBinATE BLASTX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0,'Sheet6 (2)'!$E$20)</c:f>
              <c:numCache>
                <c:formatCode>General</c:formatCode>
                <c:ptCount val="2"/>
                <c:pt idx="0">
                  <c:v>5943</c:v>
                </c:pt>
                <c:pt idx="1">
                  <c:v>12855</c:v>
                </c:pt>
              </c:numCache>
            </c:numRef>
          </c:val>
        </c:ser>
        <c:ser>
          <c:idx val="3"/>
          <c:order val="3"/>
          <c:tx>
            <c:strRef>
              <c:f>'Sheet6 (2)'!$A$21</c:f>
              <c:strCache>
                <c:ptCount val="1"/>
                <c:pt idx="0">
                  <c:v>DiScRIBinATE RAPSearch2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1,'Sheet6 (2)'!$E$21)</c:f>
              <c:numCache>
                <c:formatCode>General</c:formatCode>
                <c:ptCount val="2"/>
                <c:pt idx="0">
                  <c:v>94</c:v>
                </c:pt>
                <c:pt idx="1">
                  <c:v>202</c:v>
                </c:pt>
              </c:numCache>
            </c:numRef>
          </c:val>
        </c:ser>
        <c:ser>
          <c:idx val="4"/>
          <c:order val="4"/>
          <c:tx>
            <c:strRef>
              <c:f>'Sheet6 (2)'!$A$22</c:f>
              <c:strCache>
                <c:ptCount val="1"/>
                <c:pt idx="0">
                  <c:v>Kraken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2,'Sheet6 (2)'!$E$22)</c:f>
              <c:numCache>
                <c:formatCode>General</c:formatCode>
                <c:ptCount val="2"/>
                <c:pt idx="0">
                  <c:v>1.1000000000000001</c:v>
                </c:pt>
                <c:pt idx="1">
                  <c:v>1.1800000000000002</c:v>
                </c:pt>
              </c:numCache>
            </c:numRef>
          </c:val>
        </c:ser>
        <c:ser>
          <c:idx val="5"/>
          <c:order val="5"/>
          <c:tx>
            <c:strRef>
              <c:f>'Sheet6 (2)'!$A$23</c:f>
              <c:strCache>
                <c:ptCount val="1"/>
                <c:pt idx="0">
                  <c:v>Megan4 BLASTN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3,'Sheet6 (2)'!$E$23)</c:f>
              <c:numCache>
                <c:formatCode>General</c:formatCode>
                <c:ptCount val="2"/>
                <c:pt idx="0">
                  <c:v>19</c:v>
                </c:pt>
                <c:pt idx="1">
                  <c:v>33</c:v>
                </c:pt>
              </c:numCache>
            </c:numRef>
          </c:val>
        </c:ser>
        <c:ser>
          <c:idx val="6"/>
          <c:order val="6"/>
          <c:tx>
            <c:strRef>
              <c:f>'Sheet6 (2)'!$A$24</c:f>
              <c:strCache>
                <c:ptCount val="1"/>
                <c:pt idx="0">
                  <c:v>Megan4 BLASTX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4,'Sheet6 (2)'!$E$24)</c:f>
              <c:numCache>
                <c:formatCode>General</c:formatCode>
                <c:ptCount val="2"/>
                <c:pt idx="0">
                  <c:v>5950</c:v>
                </c:pt>
                <c:pt idx="1">
                  <c:v>12864</c:v>
                </c:pt>
              </c:numCache>
            </c:numRef>
          </c:val>
        </c:ser>
        <c:ser>
          <c:idx val="7"/>
          <c:order val="7"/>
          <c:tx>
            <c:strRef>
              <c:f>'Sheet6 (2)'!$A$25</c:f>
              <c:strCache>
                <c:ptCount val="1"/>
                <c:pt idx="0">
                  <c:v>Megan4 RAPSearch2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5,'Sheet6 (2)'!$E$25)</c:f>
              <c:numCache>
                <c:formatCode>General</c:formatCode>
                <c:ptCount val="2"/>
                <c:pt idx="0">
                  <c:v>95</c:v>
                </c:pt>
                <c:pt idx="1">
                  <c:v>206</c:v>
                </c:pt>
              </c:numCache>
            </c:numRef>
          </c:val>
        </c:ser>
        <c:ser>
          <c:idx val="8"/>
          <c:order val="8"/>
          <c:tx>
            <c:strRef>
              <c:f>'Sheet6 (2)'!$A$26</c:f>
              <c:strCache>
                <c:ptCount val="1"/>
                <c:pt idx="0">
                  <c:v>MetaBin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6,'Sheet6 (2)'!$E$26)</c:f>
              <c:numCache>
                <c:formatCode>General</c:formatCode>
                <c:ptCount val="2"/>
                <c:pt idx="0">
                  <c:v>5941</c:v>
                </c:pt>
                <c:pt idx="1">
                  <c:v>12879</c:v>
                </c:pt>
              </c:numCache>
            </c:numRef>
          </c:val>
        </c:ser>
        <c:ser>
          <c:idx val="9"/>
          <c:order val="9"/>
          <c:tx>
            <c:strRef>
              <c:f>'Sheet6 (2)'!$A$27</c:f>
              <c:strCache>
                <c:ptCount val="1"/>
                <c:pt idx="0">
                  <c:v>MetaCV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7,'Sheet6 (2)'!$E$27)</c:f>
              <c:numCache>
                <c:formatCode>General</c:formatCode>
                <c:ptCount val="2"/>
                <c:pt idx="0">
                  <c:v>31</c:v>
                </c:pt>
                <c:pt idx="1">
                  <c:v>55</c:v>
                </c:pt>
              </c:numCache>
            </c:numRef>
          </c:val>
        </c:ser>
        <c:ser>
          <c:idx val="10"/>
          <c:order val="10"/>
          <c:tx>
            <c:strRef>
              <c:f>'Sheet6 (2)'!$A$28</c:f>
              <c:strCache>
                <c:ptCount val="1"/>
                <c:pt idx="0">
                  <c:v>MetaPhyler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8,'Sheet6 (2)'!$E$28)</c:f>
              <c:numCache>
                <c:formatCode>General</c:formatCode>
                <c:ptCount val="2"/>
                <c:pt idx="0">
                  <c:v>30</c:v>
                </c:pt>
                <c:pt idx="1">
                  <c:v>64</c:v>
                </c:pt>
              </c:numCache>
            </c:numRef>
          </c:val>
        </c:ser>
        <c:ser>
          <c:idx val="11"/>
          <c:order val="11"/>
          <c:tx>
            <c:strRef>
              <c:f>'Sheet6 (2)'!$A$29</c:f>
              <c:strCache>
                <c:ptCount val="1"/>
                <c:pt idx="0">
                  <c:v>PhymmBL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29,'Sheet6 (2)'!$E$29)</c:f>
              <c:numCache>
                <c:formatCode>General</c:formatCode>
                <c:ptCount val="2"/>
                <c:pt idx="0">
                  <c:v>421</c:v>
                </c:pt>
                <c:pt idx="1">
                  <c:v>838</c:v>
                </c:pt>
              </c:numCache>
            </c:numRef>
          </c:val>
        </c:ser>
        <c:ser>
          <c:idx val="12"/>
          <c:order val="12"/>
          <c:tx>
            <c:strRef>
              <c:f>'Sheet6 (2)'!$A$30</c:f>
              <c:strCache>
                <c:ptCount val="1"/>
                <c:pt idx="0">
                  <c:v>RITA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30,'Sheet6 (2)'!$E$30)</c:f>
              <c:numCache>
                <c:formatCode>General</c:formatCode>
                <c:ptCount val="2"/>
                <c:pt idx="0">
                  <c:v>581</c:v>
                </c:pt>
                <c:pt idx="1">
                  <c:v>1326</c:v>
                </c:pt>
              </c:numCache>
            </c:numRef>
          </c:val>
        </c:ser>
        <c:ser>
          <c:idx val="13"/>
          <c:order val="13"/>
          <c:tx>
            <c:strRef>
              <c:f>'Sheet6 (2)'!$A$31</c:f>
              <c:strCache>
                <c:ptCount val="1"/>
                <c:pt idx="0">
                  <c:v>TACOA</c:v>
                </c:pt>
              </c:strCache>
            </c:strRef>
          </c:tx>
          <c:marker>
            <c:symbol val="none"/>
          </c:marker>
          <c:cat>
            <c:strRef>
              <c:f>('Sheet6 (2)'!$C$17,'Sheet6 (2)'!$E$17)</c:f>
              <c:strCache>
                <c:ptCount val="2"/>
                <c:pt idx="0">
                  <c:v>22k</c:v>
                </c:pt>
                <c:pt idx="1">
                  <c:v>44k</c:v>
                </c:pt>
              </c:strCache>
            </c:strRef>
          </c:cat>
          <c:val>
            <c:numRef>
              <c:f>('Sheet6 (2)'!$C$31,'Sheet6 (2)'!$E$31)</c:f>
              <c:numCache>
                <c:formatCode>General</c:formatCode>
                <c:ptCount val="2"/>
                <c:pt idx="0">
                  <c:v>4291</c:v>
                </c:pt>
                <c:pt idx="1">
                  <c:v>8658</c:v>
                </c:pt>
              </c:numCache>
            </c:numRef>
          </c:val>
        </c:ser>
        <c:dLbls/>
        <c:marker val="1"/>
        <c:axId val="109006848"/>
        <c:axId val="109008768"/>
      </c:lineChart>
      <c:catAx>
        <c:axId val="10900684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CA" sz="1200"/>
                  <a:t>Number of reads run</a:t>
                </a:r>
              </a:p>
            </c:rich>
          </c:tx>
        </c:title>
        <c:tickLblPos val="nextTo"/>
        <c:crossAx val="109008768"/>
        <c:crosses val="autoZero"/>
        <c:auto val="1"/>
        <c:lblAlgn val="ctr"/>
        <c:lblOffset val="100"/>
      </c:catAx>
      <c:valAx>
        <c:axId val="109008768"/>
        <c:scaling>
          <c:logBase val="10"/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200" b="1" i="0" baseline="0">
                    <a:effectLst/>
                  </a:rPr>
                  <a:t>Running time (minutes)</a:t>
                </a:r>
                <a:endParaRPr lang="en-CA" sz="1200">
                  <a:effectLst/>
                </a:endParaRPr>
              </a:p>
            </c:rich>
          </c:tx>
        </c:title>
        <c:numFmt formatCode="General" sourceLinked="1"/>
        <c:tickLblPos val="nextTo"/>
        <c:crossAx val="109006848"/>
        <c:crosses val="autoZero"/>
        <c:crossBetween val="between"/>
      </c:valAx>
    </c:plotArea>
    <c:legend>
      <c:legendPos val="r"/>
    </c:legend>
    <c:plotVisOnly val="1"/>
    <c:dispBlanksAs val="gap"/>
  </c:chart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7.6019316276494067E-2"/>
          <c:y val="4.7250347222222232E-2"/>
          <c:w val="0.67752200925093631"/>
          <c:h val="0.48754409722222231"/>
        </c:manualLayout>
      </c:layout>
      <c:barChart>
        <c:barDir val="col"/>
        <c:grouping val="clustered"/>
        <c:ser>
          <c:idx val="0"/>
          <c:order val="0"/>
          <c:tx>
            <c:strRef>
              <c:f>'250_nothing'!$F$2</c:f>
              <c:strCache>
                <c:ptCount val="1"/>
                <c:pt idx="0">
                  <c:v>Taxonomic Distance</c:v>
                </c:pt>
              </c:strCache>
            </c:strRef>
          </c:tx>
          <c:cat>
            <c:strRef>
              <c:f>'250_nothing'!$E$3:$E$19</c:f>
              <c:strCache>
                <c:ptCount val="17"/>
                <c:pt idx="0">
                  <c:v>CARMA3</c:v>
                </c:pt>
                <c:pt idx="1">
                  <c:v>CLARK</c:v>
                </c:pt>
                <c:pt idx="2">
                  <c:v>DiScRIBinATE BLASTX</c:v>
                </c:pt>
                <c:pt idx="3">
                  <c:v>DiScRIBinATE RAPSearch2</c:v>
                </c:pt>
                <c:pt idx="4">
                  <c:v>Kraken</c:v>
                </c:pt>
                <c:pt idx="5">
                  <c:v>Filtered Kraken</c:v>
                </c:pt>
                <c:pt idx="6">
                  <c:v>MEGAN4 BLASTN</c:v>
                </c:pt>
                <c:pt idx="7">
                  <c:v>MEGAN4 BLASTX</c:v>
                </c:pt>
                <c:pt idx="8">
                  <c:v>MEGAN4 RAPSearch2</c:v>
                </c:pt>
                <c:pt idx="9">
                  <c:v>MetaBin</c:v>
                </c:pt>
                <c:pt idx="10">
                  <c:v>MetaCV</c:v>
                </c:pt>
                <c:pt idx="11">
                  <c:v>MetaPhyler</c:v>
                </c:pt>
                <c:pt idx="12">
                  <c:v>PhymmBL</c:v>
                </c:pt>
                <c:pt idx="13">
                  <c:v>RITA</c:v>
                </c:pt>
                <c:pt idx="14">
                  <c:v>TACOA</c:v>
                </c:pt>
                <c:pt idx="15">
                  <c:v>MG-RAST best hit</c:v>
                </c:pt>
                <c:pt idx="16">
                  <c:v>MG-RAST LCA</c:v>
                </c:pt>
              </c:strCache>
            </c:strRef>
          </c:cat>
          <c:val>
            <c:numRef>
              <c:f>'250_nothing'!$F$3:$F$19</c:f>
              <c:numCache>
                <c:formatCode>General</c:formatCode>
                <c:ptCount val="17"/>
                <c:pt idx="0">
                  <c:v>0.26379418053358794</c:v>
                </c:pt>
                <c:pt idx="1">
                  <c:v>6.1482480850850816E-3</c:v>
                </c:pt>
                <c:pt idx="2">
                  <c:v>1.3178107839734099</c:v>
                </c:pt>
                <c:pt idx="3">
                  <c:v>2.05299004944963</c:v>
                </c:pt>
                <c:pt idx="4">
                  <c:v>7.6360561218439512E-3</c:v>
                </c:pt>
                <c:pt idx="5">
                  <c:v>1.6963156823639504E-2</c:v>
                </c:pt>
                <c:pt idx="6">
                  <c:v>3.82436692388941E-2</c:v>
                </c:pt>
                <c:pt idx="7">
                  <c:v>0.4425286191649751</c:v>
                </c:pt>
                <c:pt idx="8">
                  <c:v>0.40272131959857599</c:v>
                </c:pt>
                <c:pt idx="9">
                  <c:v>0.15517758353679603</c:v>
                </c:pt>
                <c:pt idx="10">
                  <c:v>0.13214010120466999</c:v>
                </c:pt>
                <c:pt idx="11" formatCode="0.00E+00">
                  <c:v>1.1879272103538598</c:v>
                </c:pt>
                <c:pt idx="12">
                  <c:v>0.91862080039949423</c:v>
                </c:pt>
                <c:pt idx="13">
                  <c:v>0</c:v>
                </c:pt>
                <c:pt idx="14">
                  <c:v>4.1606457714719394</c:v>
                </c:pt>
                <c:pt idx="15">
                  <c:v>0</c:v>
                </c:pt>
                <c:pt idx="16">
                  <c:v>0.75633799999999984</c:v>
                </c:pt>
              </c:numCache>
            </c:numRef>
          </c:val>
        </c:ser>
        <c:dLbls/>
        <c:axId val="106974592"/>
        <c:axId val="106980480"/>
      </c:barChart>
      <c:catAx>
        <c:axId val="106974592"/>
        <c:scaling>
          <c:orientation val="minMax"/>
        </c:scaling>
        <c:axPos val="b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106980480"/>
        <c:crosses val="autoZero"/>
        <c:auto val="1"/>
        <c:lblAlgn val="ctr"/>
        <c:lblOffset val="100"/>
      </c:catAx>
      <c:valAx>
        <c:axId val="106980480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06974592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legend>
      <c:legendPos val="r"/>
      <c:layout/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</c:chart>
  <c:spPr>
    <a:ln>
      <a:solidFill>
        <a:schemeClr val="bg1"/>
      </a:solidFill>
    </a:ln>
  </c:sp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8.0663398692810542E-2"/>
          <c:y val="4.8959027777777775E-2"/>
          <c:w val="0.75416993464052307"/>
          <c:h val="0.49024513888888877"/>
        </c:manualLayout>
      </c:layout>
      <c:barChart>
        <c:barDir val="col"/>
        <c:grouping val="clustered"/>
        <c:ser>
          <c:idx val="0"/>
          <c:order val="0"/>
          <c:tx>
            <c:strRef>
              <c:f>'250_Figures'!$B$39</c:f>
              <c:strCache>
                <c:ptCount val="1"/>
                <c:pt idx="0">
                  <c:v>species</c:v>
                </c:pt>
              </c:strCache>
            </c:strRef>
          </c:tx>
          <c:cat>
            <c:strRef>
              <c:f>'250_Figures'!$A$40:$A$50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B$40:$B$50</c:f>
              <c:numCache>
                <c:formatCode>General</c:formatCode>
                <c:ptCount val="11"/>
                <c:pt idx="0">
                  <c:v>1.1535200573656195</c:v>
                </c:pt>
                <c:pt idx="1">
                  <c:v>5.4610877892078115E-2</c:v>
                </c:pt>
                <c:pt idx="2">
                  <c:v>1.8083202333921695</c:v>
                </c:pt>
                <c:pt idx="3">
                  <c:v>0.11006294915227302</c:v>
                </c:pt>
                <c:pt idx="4">
                  <c:v>1.2391727659076099</c:v>
                </c:pt>
                <c:pt idx="5">
                  <c:v>0.21615263678378097</c:v>
                </c:pt>
                <c:pt idx="6">
                  <c:v>0.95369684825724299</c:v>
                </c:pt>
                <c:pt idx="7">
                  <c:v>1.0059789978424494</c:v>
                </c:pt>
                <c:pt idx="8">
                  <c:v>0.4258460170131621</c:v>
                </c:pt>
                <c:pt idx="9">
                  <c:v>0.80177298994702251</c:v>
                </c:pt>
                <c:pt idx="10">
                  <c:v>3.4427441487286901</c:v>
                </c:pt>
              </c:numCache>
            </c:numRef>
          </c:val>
        </c:ser>
        <c:ser>
          <c:idx val="1"/>
          <c:order val="1"/>
          <c:tx>
            <c:strRef>
              <c:f>'250_Figures'!$C$39</c:f>
              <c:strCache>
                <c:ptCount val="1"/>
                <c:pt idx="0">
                  <c:v>genus</c:v>
                </c:pt>
              </c:strCache>
            </c:strRef>
          </c:tx>
          <c:cat>
            <c:strRef>
              <c:f>'250_Figures'!$A$40:$A$50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C$40:$C$50</c:f>
              <c:numCache>
                <c:formatCode>General</c:formatCode>
                <c:ptCount val="11"/>
                <c:pt idx="0">
                  <c:v>1.41607890527278</c:v>
                </c:pt>
                <c:pt idx="1">
                  <c:v>4.0809119379728996E-2</c:v>
                </c:pt>
                <c:pt idx="2">
                  <c:v>1.4273944433903594</c:v>
                </c:pt>
                <c:pt idx="3">
                  <c:v>0.15063329490553801</c:v>
                </c:pt>
                <c:pt idx="4">
                  <c:v>1.7295344164830695</c:v>
                </c:pt>
                <c:pt idx="5">
                  <c:v>0.32989898863041922</c:v>
                </c:pt>
                <c:pt idx="6">
                  <c:v>1.0762038408275201</c:v>
                </c:pt>
                <c:pt idx="7">
                  <c:v>1.27277953373257</c:v>
                </c:pt>
                <c:pt idx="8">
                  <c:v>0.44852737347317501</c:v>
                </c:pt>
                <c:pt idx="9">
                  <c:v>0.687118922269916</c:v>
                </c:pt>
                <c:pt idx="10">
                  <c:v>2.71325060812448</c:v>
                </c:pt>
              </c:numCache>
            </c:numRef>
          </c:val>
        </c:ser>
        <c:ser>
          <c:idx val="2"/>
          <c:order val="2"/>
          <c:tx>
            <c:strRef>
              <c:f>'250_Figures'!$D$39</c:f>
              <c:strCache>
                <c:ptCount val="1"/>
                <c:pt idx="0">
                  <c:v>family</c:v>
                </c:pt>
              </c:strCache>
            </c:strRef>
          </c:tx>
          <c:cat>
            <c:strRef>
              <c:f>'250_Figures'!$A$40:$A$50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D$40:$D$50</c:f>
              <c:numCache>
                <c:formatCode>General</c:formatCode>
                <c:ptCount val="11"/>
                <c:pt idx="0">
                  <c:v>1.04119296836788</c:v>
                </c:pt>
                <c:pt idx="1">
                  <c:v>2.1587282724842408E-2</c:v>
                </c:pt>
                <c:pt idx="2">
                  <c:v>1.0782646737984198</c:v>
                </c:pt>
                <c:pt idx="3">
                  <c:v>9.9201409537282542E-2</c:v>
                </c:pt>
                <c:pt idx="4">
                  <c:v>1.68487963997735</c:v>
                </c:pt>
                <c:pt idx="5">
                  <c:v>0.2618811643333081</c:v>
                </c:pt>
                <c:pt idx="6">
                  <c:v>0.90312187772758923</c:v>
                </c:pt>
                <c:pt idx="7">
                  <c:v>1.07564153844864</c:v>
                </c:pt>
                <c:pt idx="8">
                  <c:v>0.35241522120784829</c:v>
                </c:pt>
                <c:pt idx="9">
                  <c:v>0.65933854510168</c:v>
                </c:pt>
                <c:pt idx="10">
                  <c:v>2.01215207041251</c:v>
                </c:pt>
              </c:numCache>
            </c:numRef>
          </c:val>
        </c:ser>
        <c:ser>
          <c:idx val="3"/>
          <c:order val="3"/>
          <c:tx>
            <c:strRef>
              <c:f>'250_Figures'!$E$39</c:f>
              <c:strCache>
                <c:ptCount val="1"/>
                <c:pt idx="0">
                  <c:v>order</c:v>
                </c:pt>
              </c:strCache>
            </c:strRef>
          </c:tx>
          <c:cat>
            <c:strRef>
              <c:f>'250_Figures'!$A$40:$A$50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E$40:$E$50</c:f>
              <c:numCache>
                <c:formatCode>General</c:formatCode>
                <c:ptCount val="11"/>
                <c:pt idx="0">
                  <c:v>0.7039514378935966</c:v>
                </c:pt>
                <c:pt idx="1">
                  <c:v>1.1770890070462105E-3</c:v>
                </c:pt>
                <c:pt idx="2">
                  <c:v>0.508743824057729</c:v>
                </c:pt>
                <c:pt idx="3">
                  <c:v>5.9843341991893229E-2</c:v>
                </c:pt>
                <c:pt idx="4">
                  <c:v>1.1863577322360606</c:v>
                </c:pt>
                <c:pt idx="5">
                  <c:v>0.15107920313194606</c:v>
                </c:pt>
                <c:pt idx="6">
                  <c:v>0.58065013814076583</c:v>
                </c:pt>
                <c:pt idx="7">
                  <c:v>0.72366809882823802</c:v>
                </c:pt>
                <c:pt idx="8">
                  <c:v>0.21797091281215905</c:v>
                </c:pt>
                <c:pt idx="9">
                  <c:v>0.21850347389616911</c:v>
                </c:pt>
                <c:pt idx="10">
                  <c:v>1.29442807422258</c:v>
                </c:pt>
              </c:numCache>
            </c:numRef>
          </c:val>
        </c:ser>
        <c:ser>
          <c:idx val="4"/>
          <c:order val="4"/>
          <c:tx>
            <c:strRef>
              <c:f>'250_Figures'!$F$39</c:f>
              <c:strCache>
                <c:ptCount val="1"/>
                <c:pt idx="0">
                  <c:v>class</c:v>
                </c:pt>
              </c:strCache>
            </c:strRef>
          </c:tx>
          <c:cat>
            <c:strRef>
              <c:f>'250_Figures'!$A$40:$A$50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F$40:$F$50</c:f>
              <c:numCache>
                <c:formatCode>General</c:formatCode>
                <c:ptCount val="11"/>
                <c:pt idx="0">
                  <c:v>0.54613741852982822</c:v>
                </c:pt>
                <c:pt idx="1">
                  <c:v>0</c:v>
                </c:pt>
                <c:pt idx="2">
                  <c:v>2.9749924011707299E-2</c:v>
                </c:pt>
                <c:pt idx="3">
                  <c:v>4.3792402443523136E-2</c:v>
                </c:pt>
                <c:pt idx="4">
                  <c:v>0.72435316621363099</c:v>
                </c:pt>
                <c:pt idx="5">
                  <c:v>0.15696874733895005</c:v>
                </c:pt>
                <c:pt idx="6">
                  <c:v>0.4259610201229021</c:v>
                </c:pt>
                <c:pt idx="7">
                  <c:v>0.4630141805387501</c:v>
                </c:pt>
                <c:pt idx="8">
                  <c:v>8.6163058045244198E-2</c:v>
                </c:pt>
                <c:pt idx="9">
                  <c:v>0</c:v>
                </c:pt>
                <c:pt idx="10">
                  <c:v>0.55491765097299883</c:v>
                </c:pt>
              </c:numCache>
            </c:numRef>
          </c:val>
        </c:ser>
        <c:dLbls/>
        <c:axId val="107181952"/>
        <c:axId val="107183488"/>
      </c:barChart>
      <c:catAx>
        <c:axId val="107181952"/>
        <c:scaling>
          <c:orientation val="minMax"/>
        </c:scaling>
        <c:axPos val="b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07183488"/>
        <c:crosses val="autoZero"/>
        <c:auto val="1"/>
        <c:lblAlgn val="ctr"/>
        <c:lblOffset val="100"/>
      </c:catAx>
      <c:valAx>
        <c:axId val="10718348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CA" sz="1100"/>
                  <a:t>Taxonomic distance</a:t>
                </a:r>
              </a:p>
            </c:rich>
          </c:tx>
          <c:layout/>
        </c:title>
        <c:numFmt formatCode="General" sourceLinked="1"/>
        <c:tickLblPos val="nextTo"/>
        <c:crossAx val="107181952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5766013071895419"/>
          <c:y val="0.18585486111111116"/>
          <c:w val="0.10498692810457515"/>
          <c:h val="0.42544270833333331"/>
        </c:manualLayout>
      </c:layout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</c:chart>
  <c:spPr>
    <a:ln>
      <a:solidFill>
        <a:schemeClr val="bg1"/>
      </a:solidFill>
    </a:ln>
  </c:spPr>
  <c:externalData r:id="rId1"/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0.16349349579477751"/>
          <c:y val="4.6846074620419287E-2"/>
          <c:w val="0.61054562522750355"/>
          <c:h val="0.54986943087810236"/>
        </c:manualLayout>
      </c:layout>
      <c:barChart>
        <c:barDir val="col"/>
        <c:grouping val="stacked"/>
        <c:ser>
          <c:idx val="0"/>
          <c:order val="0"/>
          <c:tx>
            <c:strRef>
              <c:f>'250_Figures'!$I$22</c:f>
              <c:strCache>
                <c:ptCount val="1"/>
                <c:pt idx="0">
                  <c:v>Species</c:v>
                </c:pt>
              </c:strCache>
            </c:strRef>
          </c:tx>
          <c:cat>
            <c:strRef>
              <c:f>'250_Figures'!$H$23:$H$3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I$23:$I$33</c:f>
              <c:numCache>
                <c:formatCode>General</c:formatCode>
                <c:ptCount val="11"/>
                <c:pt idx="0">
                  <c:v>153</c:v>
                </c:pt>
                <c:pt idx="1">
                  <c:v>12321</c:v>
                </c:pt>
                <c:pt idx="2">
                  <c:v>0</c:v>
                </c:pt>
                <c:pt idx="3">
                  <c:v>12268</c:v>
                </c:pt>
                <c:pt idx="4">
                  <c:v>262</c:v>
                </c:pt>
                <c:pt idx="5">
                  <c:v>19996</c:v>
                </c:pt>
                <c:pt idx="6">
                  <c:v>19271</c:v>
                </c:pt>
                <c:pt idx="7">
                  <c:v>19703</c:v>
                </c:pt>
                <c:pt idx="8">
                  <c:v>91569</c:v>
                </c:pt>
                <c:pt idx="9">
                  <c:v>20</c:v>
                </c:pt>
                <c:pt idx="10">
                  <c:v>0</c:v>
                </c:pt>
              </c:numCache>
            </c:numRef>
          </c:val>
        </c:ser>
        <c:ser>
          <c:idx val="1"/>
          <c:order val="1"/>
          <c:tx>
            <c:strRef>
              <c:f>'250_Figures'!$J$22</c:f>
              <c:strCache>
                <c:ptCount val="1"/>
                <c:pt idx="0">
                  <c:v>Genus</c:v>
                </c:pt>
              </c:strCache>
            </c:strRef>
          </c:tx>
          <c:cat>
            <c:strRef>
              <c:f>'250_Figures'!$H$23:$H$3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J$23:$J$33</c:f>
              <c:numCache>
                <c:formatCode>General</c:formatCode>
                <c:ptCount val="11"/>
                <c:pt idx="0">
                  <c:v>2519</c:v>
                </c:pt>
                <c:pt idx="1">
                  <c:v>1507</c:v>
                </c:pt>
                <c:pt idx="2">
                  <c:v>0</c:v>
                </c:pt>
                <c:pt idx="3">
                  <c:v>1081</c:v>
                </c:pt>
                <c:pt idx="4">
                  <c:v>73</c:v>
                </c:pt>
                <c:pt idx="5">
                  <c:v>2651</c:v>
                </c:pt>
                <c:pt idx="6">
                  <c:v>4661</c:v>
                </c:pt>
                <c:pt idx="7">
                  <c:v>4058</c:v>
                </c:pt>
                <c:pt idx="8">
                  <c:v>8671</c:v>
                </c:pt>
                <c:pt idx="9">
                  <c:v>19</c:v>
                </c:pt>
                <c:pt idx="10">
                  <c:v>8127</c:v>
                </c:pt>
              </c:numCache>
            </c:numRef>
          </c:val>
        </c:ser>
        <c:ser>
          <c:idx val="2"/>
          <c:order val="2"/>
          <c:tx>
            <c:strRef>
              <c:f>'250_Figures'!$K$22</c:f>
              <c:strCache>
                <c:ptCount val="1"/>
                <c:pt idx="0">
                  <c:v>Family</c:v>
                </c:pt>
              </c:strCache>
            </c:strRef>
          </c:tx>
          <c:cat>
            <c:strRef>
              <c:f>'250_Figures'!$H$23:$H$3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K$23:$K$33</c:f>
              <c:numCache>
                <c:formatCode>General</c:formatCode>
                <c:ptCount val="11"/>
                <c:pt idx="0">
                  <c:v>7279</c:v>
                </c:pt>
                <c:pt idx="1">
                  <c:v>445</c:v>
                </c:pt>
                <c:pt idx="2">
                  <c:v>10558</c:v>
                </c:pt>
                <c:pt idx="3">
                  <c:v>261</c:v>
                </c:pt>
                <c:pt idx="4">
                  <c:v>26</c:v>
                </c:pt>
                <c:pt idx="5">
                  <c:v>984</c:v>
                </c:pt>
                <c:pt idx="6">
                  <c:v>3386</c:v>
                </c:pt>
                <c:pt idx="7">
                  <c:v>2789</c:v>
                </c:pt>
                <c:pt idx="8">
                  <c:v>2795</c:v>
                </c:pt>
                <c:pt idx="9">
                  <c:v>23</c:v>
                </c:pt>
                <c:pt idx="10">
                  <c:v>0</c:v>
                </c:pt>
              </c:numCache>
            </c:numRef>
          </c:val>
        </c:ser>
        <c:ser>
          <c:idx val="3"/>
          <c:order val="3"/>
          <c:tx>
            <c:strRef>
              <c:f>'250_Figures'!$L$22</c:f>
              <c:strCache>
                <c:ptCount val="1"/>
                <c:pt idx="0">
                  <c:v>Order</c:v>
                </c:pt>
              </c:strCache>
            </c:strRef>
          </c:tx>
          <c:cat>
            <c:strRef>
              <c:f>'250_Figures'!$H$23:$H$3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L$23:$L$33</c:f>
              <c:numCache>
                <c:formatCode>General</c:formatCode>
                <c:ptCount val="11"/>
                <c:pt idx="0">
                  <c:v>5472</c:v>
                </c:pt>
                <c:pt idx="1">
                  <c:v>194</c:v>
                </c:pt>
                <c:pt idx="2">
                  <c:v>2019</c:v>
                </c:pt>
                <c:pt idx="3">
                  <c:v>113</c:v>
                </c:pt>
                <c:pt idx="4">
                  <c:v>58</c:v>
                </c:pt>
                <c:pt idx="5">
                  <c:v>577</c:v>
                </c:pt>
                <c:pt idx="6">
                  <c:v>2189</c:v>
                </c:pt>
                <c:pt idx="7">
                  <c:v>2140</c:v>
                </c:pt>
                <c:pt idx="8">
                  <c:v>1562</c:v>
                </c:pt>
                <c:pt idx="9">
                  <c:v>93</c:v>
                </c:pt>
                <c:pt idx="10">
                  <c:v>1481</c:v>
                </c:pt>
              </c:numCache>
            </c:numRef>
          </c:val>
        </c:ser>
        <c:ser>
          <c:idx val="4"/>
          <c:order val="4"/>
          <c:tx>
            <c:strRef>
              <c:f>'250_Figures'!$M$22</c:f>
              <c:strCache>
                <c:ptCount val="1"/>
                <c:pt idx="0">
                  <c:v>Class</c:v>
                </c:pt>
              </c:strCache>
            </c:strRef>
          </c:tx>
          <c:cat>
            <c:strRef>
              <c:f>'250_Figures'!$H$23:$H$3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M$23:$M$33</c:f>
              <c:numCache>
                <c:formatCode>General</c:formatCode>
                <c:ptCount val="11"/>
                <c:pt idx="0">
                  <c:v>5012</c:v>
                </c:pt>
                <c:pt idx="1">
                  <c:v>69</c:v>
                </c:pt>
                <c:pt idx="2">
                  <c:v>1717</c:v>
                </c:pt>
                <c:pt idx="3">
                  <c:v>87</c:v>
                </c:pt>
                <c:pt idx="4">
                  <c:v>8</c:v>
                </c:pt>
                <c:pt idx="5">
                  <c:v>447</c:v>
                </c:pt>
                <c:pt idx="6">
                  <c:v>1483</c:v>
                </c:pt>
                <c:pt idx="7">
                  <c:v>1379</c:v>
                </c:pt>
                <c:pt idx="8">
                  <c:v>1054</c:v>
                </c:pt>
                <c:pt idx="9">
                  <c:v>12</c:v>
                </c:pt>
                <c:pt idx="10">
                  <c:v>1831</c:v>
                </c:pt>
              </c:numCache>
            </c:numRef>
          </c:val>
        </c:ser>
        <c:ser>
          <c:idx val="5"/>
          <c:order val="5"/>
          <c:tx>
            <c:strRef>
              <c:f>'250_Figures'!$N$22</c:f>
              <c:strCache>
                <c:ptCount val="1"/>
                <c:pt idx="0">
                  <c:v>Phylum</c:v>
                </c:pt>
              </c:strCache>
            </c:strRef>
          </c:tx>
          <c:cat>
            <c:strRef>
              <c:f>'250_Figures'!$H$23:$H$3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N$23:$N$33</c:f>
              <c:numCache>
                <c:formatCode>General</c:formatCode>
                <c:ptCount val="11"/>
                <c:pt idx="0">
                  <c:v>2278</c:v>
                </c:pt>
                <c:pt idx="1">
                  <c:v>9</c:v>
                </c:pt>
                <c:pt idx="2">
                  <c:v>2694</c:v>
                </c:pt>
                <c:pt idx="3">
                  <c:v>28</c:v>
                </c:pt>
                <c:pt idx="4">
                  <c:v>0</c:v>
                </c:pt>
                <c:pt idx="5">
                  <c:v>109</c:v>
                </c:pt>
                <c:pt idx="6">
                  <c:v>485</c:v>
                </c:pt>
                <c:pt idx="7">
                  <c:v>589</c:v>
                </c:pt>
                <c:pt idx="8">
                  <c:v>1331</c:v>
                </c:pt>
                <c:pt idx="9">
                  <c:v>5</c:v>
                </c:pt>
                <c:pt idx="10">
                  <c:v>10146</c:v>
                </c:pt>
              </c:numCache>
            </c:numRef>
          </c:val>
        </c:ser>
        <c:ser>
          <c:idx val="6"/>
          <c:order val="6"/>
          <c:tx>
            <c:strRef>
              <c:f>'250_Figures'!$O$22</c:f>
              <c:strCache>
                <c:ptCount val="1"/>
                <c:pt idx="0">
                  <c:v>Superkingdom</c:v>
                </c:pt>
              </c:strCache>
            </c:strRef>
          </c:tx>
          <c:cat>
            <c:strRef>
              <c:f>'250_Figures'!$H$23:$H$3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O$23:$O$33</c:f>
              <c:numCache>
                <c:formatCode>General</c:formatCode>
                <c:ptCount val="11"/>
                <c:pt idx="0">
                  <c:v>718</c:v>
                </c:pt>
                <c:pt idx="1">
                  <c:v>0</c:v>
                </c:pt>
                <c:pt idx="2">
                  <c:v>8</c:v>
                </c:pt>
                <c:pt idx="3">
                  <c:v>2</c:v>
                </c:pt>
                <c:pt idx="4">
                  <c:v>0</c:v>
                </c:pt>
                <c:pt idx="5">
                  <c:v>15</c:v>
                </c:pt>
                <c:pt idx="6">
                  <c:v>423</c:v>
                </c:pt>
                <c:pt idx="7">
                  <c:v>530</c:v>
                </c:pt>
                <c:pt idx="8">
                  <c:v>1336</c:v>
                </c:pt>
                <c:pt idx="9">
                  <c:v>0</c:v>
                </c:pt>
                <c:pt idx="10">
                  <c:v>18589</c:v>
                </c:pt>
              </c:numCache>
            </c:numRef>
          </c:val>
        </c:ser>
        <c:dLbls/>
        <c:overlap val="100"/>
        <c:axId val="107247488"/>
        <c:axId val="107249024"/>
      </c:barChart>
      <c:catAx>
        <c:axId val="107247488"/>
        <c:scaling>
          <c:orientation val="minMax"/>
        </c:scaling>
        <c:axPos val="b"/>
        <c:tickLblPos val="nextTo"/>
        <c:crossAx val="107249024"/>
        <c:crosses val="autoZero"/>
        <c:auto val="1"/>
        <c:lblAlgn val="ctr"/>
        <c:lblOffset val="100"/>
      </c:catAx>
      <c:valAx>
        <c:axId val="10724902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CA" sz="1100" b="0"/>
                  <a:t>Number of misassigned reads</a:t>
                </a:r>
              </a:p>
            </c:rich>
          </c:tx>
          <c:layout>
            <c:manualLayout>
              <c:xMode val="edge"/>
              <c:yMode val="edge"/>
              <c:x val="2.1398930973044426E-2"/>
              <c:y val="9.668560417289615E-2"/>
            </c:manualLayout>
          </c:layout>
        </c:title>
        <c:numFmt formatCode="General" sourceLinked="1"/>
        <c:tickLblPos val="nextTo"/>
        <c:crossAx val="107247488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legend>
      <c:legendPos val="r"/>
      <c:layout/>
    </c:legend>
    <c:plotVisOnly val="1"/>
    <c:dispBlanksAs val="gap"/>
  </c:chart>
  <c:externalData r:id="rId1"/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0.162772931644414"/>
          <c:y val="4.6920323432841832E-2"/>
          <c:w val="0.62187652630377743"/>
          <c:h val="0.54915599521752267"/>
        </c:manualLayout>
      </c:layout>
      <c:barChart>
        <c:barDir val="col"/>
        <c:grouping val="stacked"/>
        <c:ser>
          <c:idx val="0"/>
          <c:order val="0"/>
          <c:tx>
            <c:strRef>
              <c:f>'250_Figures'!$I$35</c:f>
              <c:strCache>
                <c:ptCount val="1"/>
                <c:pt idx="0">
                  <c:v>Species</c:v>
                </c:pt>
              </c:strCache>
            </c:strRef>
          </c:tx>
          <c:cat>
            <c:strRef>
              <c:f>'250_Figures'!$H$36:$H$46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I$36:$I$46</c:f>
              <c:numCache>
                <c:formatCode>General</c:formatCode>
                <c:ptCount val="11"/>
                <c:pt idx="0">
                  <c:v>3843</c:v>
                </c:pt>
                <c:pt idx="1">
                  <c:v>7859</c:v>
                </c:pt>
                <c:pt idx="2">
                  <c:v>0</c:v>
                </c:pt>
                <c:pt idx="3">
                  <c:v>27482</c:v>
                </c:pt>
                <c:pt idx="4">
                  <c:v>10530</c:v>
                </c:pt>
                <c:pt idx="5">
                  <c:v>37082</c:v>
                </c:pt>
                <c:pt idx="6">
                  <c:v>37031</c:v>
                </c:pt>
                <c:pt idx="7">
                  <c:v>42280</c:v>
                </c:pt>
                <c:pt idx="8">
                  <c:v>42619</c:v>
                </c:pt>
                <c:pt idx="9">
                  <c:v>9</c:v>
                </c:pt>
                <c:pt idx="10">
                  <c:v>0</c:v>
                </c:pt>
              </c:numCache>
            </c:numRef>
          </c:val>
        </c:ser>
        <c:ser>
          <c:idx val="1"/>
          <c:order val="1"/>
          <c:tx>
            <c:strRef>
              <c:f>'250_Figures'!$J$35</c:f>
              <c:strCache>
                <c:ptCount val="1"/>
                <c:pt idx="0">
                  <c:v>Genus</c:v>
                </c:pt>
              </c:strCache>
            </c:strRef>
          </c:tx>
          <c:cat>
            <c:strRef>
              <c:f>'250_Figures'!$H$36:$H$46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J$36:$J$46</c:f>
              <c:numCache>
                <c:formatCode>General</c:formatCode>
                <c:ptCount val="11"/>
                <c:pt idx="0">
                  <c:v>19699</c:v>
                </c:pt>
                <c:pt idx="1">
                  <c:v>1053</c:v>
                </c:pt>
                <c:pt idx="2">
                  <c:v>0</c:v>
                </c:pt>
                <c:pt idx="3">
                  <c:v>640</c:v>
                </c:pt>
                <c:pt idx="4">
                  <c:v>644</c:v>
                </c:pt>
                <c:pt idx="5">
                  <c:v>2881</c:v>
                </c:pt>
                <c:pt idx="6">
                  <c:v>9343</c:v>
                </c:pt>
                <c:pt idx="7">
                  <c:v>6438</c:v>
                </c:pt>
                <c:pt idx="8">
                  <c:v>6896</c:v>
                </c:pt>
                <c:pt idx="9">
                  <c:v>127</c:v>
                </c:pt>
                <c:pt idx="10">
                  <c:v>160</c:v>
                </c:pt>
              </c:numCache>
            </c:numRef>
          </c:val>
        </c:ser>
        <c:ser>
          <c:idx val="2"/>
          <c:order val="2"/>
          <c:tx>
            <c:strRef>
              <c:f>'250_Figures'!$K$35</c:f>
              <c:strCache>
                <c:ptCount val="1"/>
                <c:pt idx="0">
                  <c:v>Family</c:v>
                </c:pt>
              </c:strCache>
            </c:strRef>
          </c:tx>
          <c:cat>
            <c:strRef>
              <c:f>'250_Figures'!$H$36:$H$46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K$36:$K$46</c:f>
              <c:numCache>
                <c:formatCode>General</c:formatCode>
                <c:ptCount val="11"/>
                <c:pt idx="0">
                  <c:v>16932</c:v>
                </c:pt>
                <c:pt idx="1">
                  <c:v>237</c:v>
                </c:pt>
                <c:pt idx="2">
                  <c:v>40485</c:v>
                </c:pt>
                <c:pt idx="3">
                  <c:v>129</c:v>
                </c:pt>
                <c:pt idx="4">
                  <c:v>151</c:v>
                </c:pt>
                <c:pt idx="5">
                  <c:v>1079</c:v>
                </c:pt>
                <c:pt idx="6">
                  <c:v>8176</c:v>
                </c:pt>
                <c:pt idx="7">
                  <c:v>6702</c:v>
                </c:pt>
                <c:pt idx="8">
                  <c:v>2957</c:v>
                </c:pt>
                <c:pt idx="9">
                  <c:v>356</c:v>
                </c:pt>
                <c:pt idx="10">
                  <c:v>0</c:v>
                </c:pt>
              </c:numCache>
            </c:numRef>
          </c:val>
        </c:ser>
        <c:ser>
          <c:idx val="3"/>
          <c:order val="3"/>
          <c:tx>
            <c:strRef>
              <c:f>'250_Figures'!$L$35</c:f>
              <c:strCache>
                <c:ptCount val="1"/>
                <c:pt idx="0">
                  <c:v>Order</c:v>
                </c:pt>
              </c:strCache>
            </c:strRef>
          </c:tx>
          <c:cat>
            <c:strRef>
              <c:f>'250_Figures'!$H$36:$H$46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L$36:$L$46</c:f>
              <c:numCache>
                <c:formatCode>General</c:formatCode>
                <c:ptCount val="11"/>
                <c:pt idx="0">
                  <c:v>34225</c:v>
                </c:pt>
                <c:pt idx="1">
                  <c:v>187</c:v>
                </c:pt>
                <c:pt idx="2">
                  <c:v>16661</c:v>
                </c:pt>
                <c:pt idx="3">
                  <c:v>779</c:v>
                </c:pt>
                <c:pt idx="4">
                  <c:v>1063</c:v>
                </c:pt>
                <c:pt idx="5">
                  <c:v>4641</c:v>
                </c:pt>
                <c:pt idx="6">
                  <c:v>19391</c:v>
                </c:pt>
                <c:pt idx="7">
                  <c:v>21751</c:v>
                </c:pt>
                <c:pt idx="8">
                  <c:v>6916</c:v>
                </c:pt>
                <c:pt idx="9">
                  <c:v>60</c:v>
                </c:pt>
                <c:pt idx="10">
                  <c:v>512</c:v>
                </c:pt>
              </c:numCache>
            </c:numRef>
          </c:val>
        </c:ser>
        <c:ser>
          <c:idx val="4"/>
          <c:order val="4"/>
          <c:tx>
            <c:strRef>
              <c:f>'250_Figures'!$M$35</c:f>
              <c:strCache>
                <c:ptCount val="1"/>
                <c:pt idx="0">
                  <c:v>Class</c:v>
                </c:pt>
              </c:strCache>
            </c:strRef>
          </c:tx>
          <c:cat>
            <c:strRef>
              <c:f>'250_Figures'!$H$36:$H$46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M$36:$M$46</c:f>
              <c:numCache>
                <c:formatCode>General</c:formatCode>
                <c:ptCount val="11"/>
                <c:pt idx="0">
                  <c:v>19610</c:v>
                </c:pt>
                <c:pt idx="1">
                  <c:v>229</c:v>
                </c:pt>
                <c:pt idx="2">
                  <c:v>18542</c:v>
                </c:pt>
                <c:pt idx="3">
                  <c:v>201</c:v>
                </c:pt>
                <c:pt idx="4">
                  <c:v>380</c:v>
                </c:pt>
                <c:pt idx="5">
                  <c:v>1019</c:v>
                </c:pt>
                <c:pt idx="6">
                  <c:v>12302</c:v>
                </c:pt>
                <c:pt idx="7">
                  <c:v>10993</c:v>
                </c:pt>
                <c:pt idx="8">
                  <c:v>3380</c:v>
                </c:pt>
                <c:pt idx="9">
                  <c:v>155</c:v>
                </c:pt>
                <c:pt idx="10">
                  <c:v>701</c:v>
                </c:pt>
              </c:numCache>
            </c:numRef>
          </c:val>
        </c:ser>
        <c:ser>
          <c:idx val="5"/>
          <c:order val="5"/>
          <c:tx>
            <c:strRef>
              <c:f>'250_Figures'!$N$35</c:f>
              <c:strCache>
                <c:ptCount val="1"/>
                <c:pt idx="0">
                  <c:v>Phylum</c:v>
                </c:pt>
              </c:strCache>
            </c:strRef>
          </c:tx>
          <c:cat>
            <c:strRef>
              <c:f>'250_Figures'!$H$36:$H$46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N$36:$N$46</c:f>
              <c:numCache>
                <c:formatCode>General</c:formatCode>
                <c:ptCount val="11"/>
                <c:pt idx="0">
                  <c:v>17452</c:v>
                </c:pt>
                <c:pt idx="1">
                  <c:v>132</c:v>
                </c:pt>
                <c:pt idx="2">
                  <c:v>33096</c:v>
                </c:pt>
                <c:pt idx="3">
                  <c:v>346</c:v>
                </c:pt>
                <c:pt idx="4">
                  <c:v>529</c:v>
                </c:pt>
                <c:pt idx="5">
                  <c:v>1817</c:v>
                </c:pt>
                <c:pt idx="6">
                  <c:v>15597</c:v>
                </c:pt>
                <c:pt idx="7">
                  <c:v>17446</c:v>
                </c:pt>
                <c:pt idx="8">
                  <c:v>5162</c:v>
                </c:pt>
                <c:pt idx="9">
                  <c:v>39</c:v>
                </c:pt>
                <c:pt idx="10">
                  <c:v>4019</c:v>
                </c:pt>
              </c:numCache>
            </c:numRef>
          </c:val>
        </c:ser>
        <c:ser>
          <c:idx val="6"/>
          <c:order val="6"/>
          <c:tx>
            <c:strRef>
              <c:f>'250_Figures'!$O$35</c:f>
              <c:strCache>
                <c:ptCount val="1"/>
                <c:pt idx="0">
                  <c:v>Superkingdom</c:v>
                </c:pt>
              </c:strCache>
            </c:strRef>
          </c:tx>
          <c:cat>
            <c:strRef>
              <c:f>'250_Figures'!$H$36:$H$46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'250_Figures'!$O$36:$O$46</c:f>
              <c:numCache>
                <c:formatCode>General</c:formatCode>
                <c:ptCount val="11"/>
                <c:pt idx="0">
                  <c:v>15117</c:v>
                </c:pt>
                <c:pt idx="1">
                  <c:v>0</c:v>
                </c:pt>
                <c:pt idx="2">
                  <c:v>400</c:v>
                </c:pt>
                <c:pt idx="3">
                  <c:v>243</c:v>
                </c:pt>
                <c:pt idx="4">
                  <c:v>595</c:v>
                </c:pt>
                <c:pt idx="5">
                  <c:v>1196</c:v>
                </c:pt>
                <c:pt idx="6">
                  <c:v>13624</c:v>
                </c:pt>
                <c:pt idx="7">
                  <c:v>23123</c:v>
                </c:pt>
                <c:pt idx="8">
                  <c:v>13690</c:v>
                </c:pt>
                <c:pt idx="9">
                  <c:v>0</c:v>
                </c:pt>
                <c:pt idx="10">
                  <c:v>98030</c:v>
                </c:pt>
              </c:numCache>
            </c:numRef>
          </c:val>
        </c:ser>
        <c:dLbls/>
        <c:overlap val="100"/>
        <c:axId val="107072128"/>
        <c:axId val="107282816"/>
      </c:barChart>
      <c:catAx>
        <c:axId val="107072128"/>
        <c:scaling>
          <c:orientation val="minMax"/>
        </c:scaling>
        <c:axPos val="b"/>
        <c:tickLblPos val="nextTo"/>
        <c:crossAx val="107282816"/>
        <c:crosses val="autoZero"/>
        <c:auto val="1"/>
        <c:lblAlgn val="ctr"/>
        <c:lblOffset val="100"/>
      </c:catAx>
      <c:valAx>
        <c:axId val="10728281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CA" sz="1100" b="0"/>
                  <a:t>Number of correctly assigned/overpredicted</a:t>
                </a:r>
                <a:r>
                  <a:rPr lang="en-CA" sz="1100" b="0" baseline="0"/>
                  <a:t> reads</a:t>
                </a:r>
                <a:endParaRPr lang="en-CA" sz="1100" b="0"/>
              </a:p>
            </c:rich>
          </c:tx>
          <c:layout>
            <c:manualLayout>
              <c:xMode val="edge"/>
              <c:yMode val="edge"/>
              <c:x val="0"/>
              <c:y val="7.2276904513837475E-2"/>
            </c:manualLayout>
          </c:layout>
        </c:title>
        <c:numFmt formatCode="General" sourceLinked="1"/>
        <c:tickLblPos val="nextTo"/>
        <c:crossAx val="107072128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legend>
      <c:legendPos val="r"/>
      <c:layout/>
    </c:legend>
    <c:plotVisOnly val="1"/>
    <c:dispBlanksAs val="gap"/>
  </c:chart>
  <c:externalData r:id="rId1"/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8.8964052287581724E-2"/>
          <c:y val="4.8959027777777775E-2"/>
          <c:w val="0.77534689542483681"/>
          <c:h val="0.49024513888888882"/>
        </c:manualLayout>
      </c:layout>
      <c:barChart>
        <c:barDir val="col"/>
        <c:grouping val="clustered"/>
        <c:ser>
          <c:idx val="0"/>
          <c:order val="0"/>
          <c:tx>
            <c:strRef>
              <c:f>Genus_excluded!$B$2</c:f>
              <c:strCache>
                <c:ptCount val="1"/>
                <c:pt idx="0">
                  <c:v>100</c:v>
                </c:pt>
              </c:strCache>
            </c:strRef>
          </c:tx>
          <c:cat>
            <c:strRef>
              <c:f>Genus_excluded!$A$3:$A$1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B$3:$B$13</c:f>
              <c:numCache>
                <c:formatCode>General</c:formatCode>
                <c:ptCount val="11"/>
                <c:pt idx="0">
                  <c:v>0.36273631921855598</c:v>
                </c:pt>
                <c:pt idx="1">
                  <c:v>3.764236464079071E-3</c:v>
                </c:pt>
                <c:pt idx="2">
                  <c:v>0.38969179301322698</c:v>
                </c:pt>
                <c:pt idx="3">
                  <c:v>5.7963669264120606E-3</c:v>
                </c:pt>
                <c:pt idx="4">
                  <c:v>1.0787770211188805E-2</c:v>
                </c:pt>
                <c:pt idx="5">
                  <c:v>2.5540286407562503E-2</c:v>
                </c:pt>
                <c:pt idx="6">
                  <c:v>0.18948232742760704</c:v>
                </c:pt>
                <c:pt idx="7">
                  <c:v>0.24680425840985401</c:v>
                </c:pt>
                <c:pt idx="8">
                  <c:v>0.164696179968426</c:v>
                </c:pt>
                <c:pt idx="9">
                  <c:v>7.3903400209984315E-4</c:v>
                </c:pt>
                <c:pt idx="10">
                  <c:v>0.47426522399401005</c:v>
                </c:pt>
              </c:numCache>
            </c:numRef>
          </c:val>
        </c:ser>
        <c:ser>
          <c:idx val="1"/>
          <c:order val="1"/>
          <c:tx>
            <c:strRef>
              <c:f>Genus_excluded!$C$2</c:f>
              <c:strCache>
                <c:ptCount val="1"/>
                <c:pt idx="0">
                  <c:v>250</c:v>
                </c:pt>
              </c:strCache>
            </c:strRef>
          </c:tx>
          <c:cat>
            <c:strRef>
              <c:f>Genus_excluded!$A$3:$A$1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C$3:$C$13</c:f>
              <c:numCache>
                <c:formatCode>General</c:formatCode>
                <c:ptCount val="11"/>
                <c:pt idx="0">
                  <c:v>0.54089833545707311</c:v>
                </c:pt>
                <c:pt idx="1">
                  <c:v>3.3702933619818706E-3</c:v>
                </c:pt>
                <c:pt idx="2">
                  <c:v>0.53386608736965691</c:v>
                </c:pt>
                <c:pt idx="3">
                  <c:v>7.2432392314287714E-3</c:v>
                </c:pt>
                <c:pt idx="4">
                  <c:v>1.2122270330360901E-2</c:v>
                </c:pt>
                <c:pt idx="5">
                  <c:v>3.9254619731310697E-2</c:v>
                </c:pt>
                <c:pt idx="6">
                  <c:v>0.35113651544756008</c:v>
                </c:pt>
                <c:pt idx="7">
                  <c:v>0.40613456877158699</c:v>
                </c:pt>
                <c:pt idx="8">
                  <c:v>0.161022988985705</c:v>
                </c:pt>
                <c:pt idx="9">
                  <c:v>1.4585521741271104E-3</c:v>
                </c:pt>
                <c:pt idx="10">
                  <c:v>0.51283276790179688</c:v>
                </c:pt>
              </c:numCache>
            </c:numRef>
          </c:val>
        </c:ser>
        <c:ser>
          <c:idx val="2"/>
          <c:order val="2"/>
          <c:tx>
            <c:strRef>
              <c:f>Genus_excluded!$D$2</c:f>
              <c:strCache>
                <c:ptCount val="1"/>
                <c:pt idx="0">
                  <c:v>500</c:v>
                </c:pt>
              </c:strCache>
            </c:strRef>
          </c:tx>
          <c:cat>
            <c:strRef>
              <c:f>Genus_excluded!$A$3:$A$1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D$3:$D$13</c:f>
              <c:numCache>
                <c:formatCode>General</c:formatCode>
                <c:ptCount val="11"/>
                <c:pt idx="0">
                  <c:v>0.62400875554007418</c:v>
                </c:pt>
                <c:pt idx="1">
                  <c:v>3.6215894236989506E-3</c:v>
                </c:pt>
                <c:pt idx="2">
                  <c:v>0.60276160285042313</c:v>
                </c:pt>
                <c:pt idx="3">
                  <c:v>8.9078609276118399E-3</c:v>
                </c:pt>
                <c:pt idx="4">
                  <c:v>1.1990395599851001E-2</c:v>
                </c:pt>
                <c:pt idx="5">
                  <c:v>5.2001326748583709E-2</c:v>
                </c:pt>
                <c:pt idx="6">
                  <c:v>0.39094011010553897</c:v>
                </c:pt>
                <c:pt idx="7">
                  <c:v>0.42661823287661904</c:v>
                </c:pt>
                <c:pt idx="8">
                  <c:v>0.165562998135585</c:v>
                </c:pt>
                <c:pt idx="9">
                  <c:v>2.1342637757639804E-3</c:v>
                </c:pt>
                <c:pt idx="10">
                  <c:v>0.54065831268048725</c:v>
                </c:pt>
              </c:numCache>
            </c:numRef>
          </c:val>
        </c:ser>
        <c:ser>
          <c:idx val="3"/>
          <c:order val="3"/>
          <c:tx>
            <c:strRef>
              <c:f>Genus_excluded!$E$2</c:f>
              <c:strCache>
                <c:ptCount val="1"/>
                <c:pt idx="0">
                  <c:v>1000</c:v>
                </c:pt>
              </c:strCache>
            </c:strRef>
          </c:tx>
          <c:cat>
            <c:strRef>
              <c:f>Genus_excluded!$A$3:$A$13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E$3:$E$13</c:f>
              <c:numCache>
                <c:formatCode>General</c:formatCode>
                <c:ptCount val="11"/>
                <c:pt idx="0">
                  <c:v>0.66285143768213517</c:v>
                </c:pt>
                <c:pt idx="1">
                  <c:v>3.7318760840649202E-3</c:v>
                </c:pt>
                <c:pt idx="2">
                  <c:v>0.65216221239260308</c:v>
                </c:pt>
                <c:pt idx="3">
                  <c:v>1.1660782590963802E-2</c:v>
                </c:pt>
                <c:pt idx="4">
                  <c:v>1.1320376111964701E-2</c:v>
                </c:pt>
                <c:pt idx="5">
                  <c:v>6.6477495044988094E-2</c:v>
                </c:pt>
                <c:pt idx="6">
                  <c:v>0.41019217907816402</c:v>
                </c:pt>
                <c:pt idx="7">
                  <c:v>0.45751725731437198</c:v>
                </c:pt>
                <c:pt idx="8">
                  <c:v>0.16815086508844698</c:v>
                </c:pt>
                <c:pt idx="9">
                  <c:v>3.1110596510286201E-3</c:v>
                </c:pt>
                <c:pt idx="10">
                  <c:v>0.56090841046178919</c:v>
                </c:pt>
              </c:numCache>
            </c:numRef>
          </c:val>
        </c:ser>
        <c:dLbls/>
        <c:axId val="107341312"/>
        <c:axId val="107342848"/>
      </c:barChart>
      <c:catAx>
        <c:axId val="107341312"/>
        <c:scaling>
          <c:orientation val="minMax"/>
        </c:scaling>
        <c:axPos val="b"/>
        <c:tickLblPos val="nextTo"/>
        <c:txPr>
          <a:bodyPr/>
          <a:lstStyle/>
          <a:p>
            <a:pPr>
              <a:defRPr sz="1050"/>
            </a:pPr>
            <a:endParaRPr lang="en-US"/>
          </a:p>
        </c:txPr>
        <c:crossAx val="107342848"/>
        <c:crosses val="autoZero"/>
        <c:auto val="1"/>
        <c:lblAlgn val="ctr"/>
        <c:lblOffset val="100"/>
      </c:catAx>
      <c:valAx>
        <c:axId val="10734284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Sensitivity</a:t>
                </a:r>
              </a:p>
            </c:rich>
          </c:tx>
          <c:layout/>
        </c:title>
        <c:numFmt formatCode="General" sourceLinked="1"/>
        <c:tickLblPos val="nextTo"/>
        <c:crossAx val="107341312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88921290849673196"/>
          <c:y val="0.13138541666666664"/>
          <c:w val="8.3809967320261469E-2"/>
          <c:h val="0.34035416666666674"/>
        </c:manualLayout>
      </c:layout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</c:chart>
  <c:spPr>
    <a:ln>
      <a:solidFill>
        <a:schemeClr val="bg1"/>
      </a:solidFill>
    </a:ln>
  </c:spPr>
  <c:externalData r:id="rId1"/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>
        <c:manualLayout>
          <c:layoutTarget val="inner"/>
          <c:xMode val="edge"/>
          <c:yMode val="edge"/>
          <c:x val="8.9360294117647066E-2"/>
          <c:y val="5.1660069444444442E-2"/>
          <c:w val="0.77080032679738564"/>
          <c:h val="0.48754409722222231"/>
        </c:manualLayout>
      </c:layout>
      <c:barChart>
        <c:barDir val="col"/>
        <c:grouping val="clustered"/>
        <c:ser>
          <c:idx val="0"/>
          <c:order val="0"/>
          <c:tx>
            <c:strRef>
              <c:f>Genus_excluded!$B$19</c:f>
              <c:strCache>
                <c:ptCount val="1"/>
                <c:pt idx="0">
                  <c:v>100</c:v>
                </c:pt>
              </c:strCache>
            </c:strRef>
          </c:tx>
          <c:cat>
            <c:strRef>
              <c:f>Genus_excluded!$A$20:$A$30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B$20:$B$30</c:f>
              <c:numCache>
                <c:formatCode>General</c:formatCode>
                <c:ptCount val="11"/>
                <c:pt idx="0">
                  <c:v>0.66842749468500706</c:v>
                </c:pt>
                <c:pt idx="1">
                  <c:v>6.5111711268403802E-2</c:v>
                </c:pt>
                <c:pt idx="2">
                  <c:v>0.73814662552259414</c:v>
                </c:pt>
                <c:pt idx="3">
                  <c:v>9.8144016886911781E-2</c:v>
                </c:pt>
                <c:pt idx="4">
                  <c:v>0.48060609918918507</c:v>
                </c:pt>
                <c:pt idx="5">
                  <c:v>0.18003091988581499</c:v>
                </c:pt>
                <c:pt idx="6">
                  <c:v>0.47316434987631401</c:v>
                </c:pt>
                <c:pt idx="7">
                  <c:v>0.48996350106176007</c:v>
                </c:pt>
                <c:pt idx="8">
                  <c:v>0.16931259449653499</c:v>
                </c:pt>
                <c:pt idx="9">
                  <c:v>0.62183066158871714</c:v>
                </c:pt>
                <c:pt idx="10">
                  <c:v>0.63882907664787336</c:v>
                </c:pt>
              </c:numCache>
            </c:numRef>
          </c:val>
        </c:ser>
        <c:ser>
          <c:idx val="1"/>
          <c:order val="1"/>
          <c:tx>
            <c:strRef>
              <c:f>Genus_excluded!$C$19</c:f>
              <c:strCache>
                <c:ptCount val="1"/>
                <c:pt idx="0">
                  <c:v>250</c:v>
                </c:pt>
              </c:strCache>
            </c:strRef>
          </c:tx>
          <c:cat>
            <c:strRef>
              <c:f>Genus_excluded!$A$20:$A$30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C$20:$C$30</c:f>
              <c:numCache>
                <c:formatCode>General</c:formatCode>
                <c:ptCount val="11"/>
                <c:pt idx="0">
                  <c:v>0.72189854683390109</c:v>
                </c:pt>
                <c:pt idx="1">
                  <c:v>3.254471203241311E-2</c:v>
                </c:pt>
                <c:pt idx="2">
                  <c:v>0.83388799732505003</c:v>
                </c:pt>
                <c:pt idx="3">
                  <c:v>6.5855238385515796E-2</c:v>
                </c:pt>
                <c:pt idx="4">
                  <c:v>0.63500932026287915</c:v>
                </c:pt>
                <c:pt idx="5">
                  <c:v>0.15236234510903504</c:v>
                </c:pt>
                <c:pt idx="6">
                  <c:v>0.47280489525353603</c:v>
                </c:pt>
                <c:pt idx="7">
                  <c:v>0.50984651068181608</c:v>
                </c:pt>
                <c:pt idx="8">
                  <c:v>0.16400034150811499</c:v>
                </c:pt>
                <c:pt idx="9">
                  <c:v>0.69490199719965995</c:v>
                </c:pt>
                <c:pt idx="10">
                  <c:v>0.68884900416549222</c:v>
                </c:pt>
              </c:numCache>
            </c:numRef>
          </c:val>
        </c:ser>
        <c:ser>
          <c:idx val="2"/>
          <c:order val="2"/>
          <c:tx>
            <c:strRef>
              <c:f>Genus_excluded!$D$19</c:f>
              <c:strCache>
                <c:ptCount val="1"/>
                <c:pt idx="0">
                  <c:v>500</c:v>
                </c:pt>
              </c:strCache>
            </c:strRef>
          </c:tx>
          <c:cat>
            <c:strRef>
              <c:f>Genus_excluded!$A$20:$A$30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D$20:$D$30</c:f>
              <c:numCache>
                <c:formatCode>General</c:formatCode>
                <c:ptCount val="11"/>
                <c:pt idx="0">
                  <c:v>0.741495018992957</c:v>
                </c:pt>
                <c:pt idx="1">
                  <c:v>2.2054020993594999E-2</c:v>
                </c:pt>
                <c:pt idx="2">
                  <c:v>0.85438974517794186</c:v>
                </c:pt>
                <c:pt idx="3">
                  <c:v>4.9153355868958498E-2</c:v>
                </c:pt>
                <c:pt idx="4">
                  <c:v>0.68586543067145911</c:v>
                </c:pt>
                <c:pt idx="5">
                  <c:v>0.137478826583117</c:v>
                </c:pt>
                <c:pt idx="6">
                  <c:v>0.44712996313724013</c:v>
                </c:pt>
                <c:pt idx="7">
                  <c:v>0.49900625473050497</c:v>
                </c:pt>
                <c:pt idx="8">
                  <c:v>0.167682229853373</c:v>
                </c:pt>
                <c:pt idx="9">
                  <c:v>0.69862671177951707</c:v>
                </c:pt>
                <c:pt idx="10">
                  <c:v>0.75166637748480614</c:v>
                </c:pt>
              </c:numCache>
            </c:numRef>
          </c:val>
        </c:ser>
        <c:ser>
          <c:idx val="3"/>
          <c:order val="3"/>
          <c:tx>
            <c:strRef>
              <c:f>Genus_excluded!$E$19</c:f>
              <c:strCache>
                <c:ptCount val="1"/>
                <c:pt idx="0">
                  <c:v>1000</c:v>
                </c:pt>
              </c:strCache>
            </c:strRef>
          </c:tx>
          <c:cat>
            <c:strRef>
              <c:f>Genus_excluded!$A$20:$A$30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E$20:$E$30</c:f>
              <c:numCache>
                <c:formatCode>General</c:formatCode>
                <c:ptCount val="11"/>
                <c:pt idx="0">
                  <c:v>0.75212373896841611</c:v>
                </c:pt>
                <c:pt idx="1">
                  <c:v>1.7402766120695898E-2</c:v>
                </c:pt>
                <c:pt idx="2">
                  <c:v>0.87031503482332595</c:v>
                </c:pt>
                <c:pt idx="3">
                  <c:v>4.5742824418954997E-2</c:v>
                </c:pt>
                <c:pt idx="4">
                  <c:v>0.60868260648034411</c:v>
                </c:pt>
                <c:pt idx="5">
                  <c:v>0.13258066233495497</c:v>
                </c:pt>
                <c:pt idx="6">
                  <c:v>0.43727906716475412</c:v>
                </c:pt>
                <c:pt idx="7">
                  <c:v>0.49400453058842708</c:v>
                </c:pt>
                <c:pt idx="8">
                  <c:v>0.16952049832218399</c:v>
                </c:pt>
                <c:pt idx="9">
                  <c:v>0.69978770878490393</c:v>
                </c:pt>
                <c:pt idx="10">
                  <c:v>0.800587382346577</c:v>
                </c:pt>
              </c:numCache>
            </c:numRef>
          </c:val>
        </c:ser>
        <c:dLbls/>
        <c:axId val="108567168"/>
        <c:axId val="108597632"/>
      </c:barChart>
      <c:catAx>
        <c:axId val="108567168"/>
        <c:scaling>
          <c:orientation val="minMax"/>
        </c:scaling>
        <c:axPos val="b"/>
        <c:tickLblPos val="nextTo"/>
        <c:txPr>
          <a:bodyPr/>
          <a:lstStyle/>
          <a:p>
            <a:pPr>
              <a:defRPr sz="1050"/>
            </a:pPr>
            <a:endParaRPr lang="en-US"/>
          </a:p>
        </c:txPr>
        <c:crossAx val="108597632"/>
        <c:crosses val="autoZero"/>
        <c:auto val="1"/>
        <c:lblAlgn val="ctr"/>
        <c:lblOffset val="100"/>
      </c:catAx>
      <c:valAx>
        <c:axId val="10859763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recision</a:t>
                </a:r>
              </a:p>
            </c:rich>
          </c:tx>
          <c:layout/>
        </c:title>
        <c:numFmt formatCode="General" sourceLinked="1"/>
        <c:tickLblPos val="nextTo"/>
        <c:crossAx val="108567168"/>
        <c:crosses val="autoZero"/>
        <c:crossBetween val="between"/>
      </c:valAx>
      <c:spPr>
        <a:noFill/>
        <a:ln w="12700"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88506258169934626"/>
          <c:y val="0.13579513888888889"/>
          <c:w val="8.3809967320261469E-2"/>
          <c:h val="0.34035416666666674"/>
        </c:manualLayout>
      </c:layout>
    </c:legend>
    <c:plotVisOnly val="1"/>
    <c:dispBlanksAs val="gap"/>
  </c:chart>
  <c:spPr>
    <a:ln>
      <a:solidFill>
        <a:schemeClr val="bg1"/>
      </a:solidFill>
    </a:ln>
  </c:spPr>
  <c:txPr>
    <a:bodyPr/>
    <a:lstStyle/>
    <a:p>
      <a:pPr>
        <a:defRPr sz="1100"/>
      </a:pPr>
      <a:endParaRPr lang="en-US"/>
    </a:p>
  </c:txPr>
  <c:externalData r:id="rId1"/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barChart>
        <c:barDir val="col"/>
        <c:grouping val="clustered"/>
        <c:ser>
          <c:idx val="0"/>
          <c:order val="0"/>
          <c:tx>
            <c:strRef>
              <c:f>Genus_excluded!$B$38</c:f>
              <c:strCache>
                <c:ptCount val="1"/>
                <c:pt idx="0">
                  <c:v>100</c:v>
                </c:pt>
              </c:strCache>
            </c:strRef>
          </c:tx>
          <c:cat>
            <c:strRef>
              <c:f>Genus_excluded!$A$39:$A$49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B$39:$B$49</c:f>
              <c:numCache>
                <c:formatCode>General</c:formatCode>
                <c:ptCount val="11"/>
                <c:pt idx="0">
                  <c:v>1.3769398510776598</c:v>
                </c:pt>
                <c:pt idx="1">
                  <c:v>8.0873410504350512E-2</c:v>
                </c:pt>
                <c:pt idx="2">
                  <c:v>1.0754153812043599</c:v>
                </c:pt>
                <c:pt idx="3">
                  <c:v>0.21344041208113906</c:v>
                </c:pt>
                <c:pt idx="4">
                  <c:v>1.2167307434783998</c:v>
                </c:pt>
                <c:pt idx="5">
                  <c:v>0.41445953877406905</c:v>
                </c:pt>
                <c:pt idx="6">
                  <c:v>1.11258913823246</c:v>
                </c:pt>
                <c:pt idx="7">
                  <c:v>1.2868187478530799</c:v>
                </c:pt>
                <c:pt idx="8">
                  <c:v>0.51406766407943294</c:v>
                </c:pt>
                <c:pt idx="9">
                  <c:v>1.1852234825357899</c:v>
                </c:pt>
                <c:pt idx="10">
                  <c:v>2.5211868796547501</c:v>
                </c:pt>
              </c:numCache>
            </c:numRef>
          </c:val>
        </c:ser>
        <c:ser>
          <c:idx val="1"/>
          <c:order val="1"/>
          <c:tx>
            <c:strRef>
              <c:f>Genus_excluded!$C$38</c:f>
              <c:strCache>
                <c:ptCount val="1"/>
                <c:pt idx="0">
                  <c:v>250</c:v>
                </c:pt>
              </c:strCache>
            </c:strRef>
          </c:tx>
          <c:cat>
            <c:strRef>
              <c:f>Genus_excluded!$A$39:$A$49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C$39:$C$49</c:f>
              <c:numCache>
                <c:formatCode>General</c:formatCode>
                <c:ptCount val="11"/>
                <c:pt idx="0">
                  <c:v>1.41607890527278</c:v>
                </c:pt>
                <c:pt idx="1">
                  <c:v>4.0809119379728996E-2</c:v>
                </c:pt>
                <c:pt idx="2">
                  <c:v>1.4273944433903596</c:v>
                </c:pt>
                <c:pt idx="3">
                  <c:v>0.15063329490553801</c:v>
                </c:pt>
                <c:pt idx="4">
                  <c:v>1.7295344164830697</c:v>
                </c:pt>
                <c:pt idx="5">
                  <c:v>0.32989898863041911</c:v>
                </c:pt>
                <c:pt idx="6">
                  <c:v>1.0762038408275201</c:v>
                </c:pt>
                <c:pt idx="7">
                  <c:v>1.2755374331931599</c:v>
                </c:pt>
                <c:pt idx="8">
                  <c:v>0.44852737347317501</c:v>
                </c:pt>
                <c:pt idx="9">
                  <c:v>1.3543502552845799</c:v>
                </c:pt>
                <c:pt idx="10">
                  <c:v>2.71325060812448</c:v>
                </c:pt>
              </c:numCache>
            </c:numRef>
          </c:val>
        </c:ser>
        <c:ser>
          <c:idx val="2"/>
          <c:order val="2"/>
          <c:tx>
            <c:strRef>
              <c:f>Genus_excluded!$D$38</c:f>
              <c:strCache>
                <c:ptCount val="1"/>
                <c:pt idx="0">
                  <c:v>500</c:v>
                </c:pt>
              </c:strCache>
            </c:strRef>
          </c:tx>
          <c:cat>
            <c:strRef>
              <c:f>Genus_excluded!$A$39:$A$49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D$39:$D$49</c:f>
              <c:numCache>
                <c:formatCode>General</c:formatCode>
                <c:ptCount val="11"/>
                <c:pt idx="0">
                  <c:v>1.4258020752514697</c:v>
                </c:pt>
                <c:pt idx="1">
                  <c:v>2.8408901783908203E-2</c:v>
                </c:pt>
                <c:pt idx="2">
                  <c:v>1.4864361321326798</c:v>
                </c:pt>
                <c:pt idx="3">
                  <c:v>0.11770707383157501</c:v>
                </c:pt>
                <c:pt idx="4">
                  <c:v>1.8882586995578001</c:v>
                </c:pt>
                <c:pt idx="5">
                  <c:v>0.29792844674565511</c:v>
                </c:pt>
                <c:pt idx="6">
                  <c:v>0.97860484536893311</c:v>
                </c:pt>
                <c:pt idx="7">
                  <c:v>1.1929119558132601</c:v>
                </c:pt>
                <c:pt idx="8">
                  <c:v>0.39925022227213408</c:v>
                </c:pt>
                <c:pt idx="9">
                  <c:v>1.2274753872819597</c:v>
                </c:pt>
                <c:pt idx="10">
                  <c:v>2.9517149106400797</c:v>
                </c:pt>
              </c:numCache>
            </c:numRef>
          </c:val>
        </c:ser>
        <c:ser>
          <c:idx val="3"/>
          <c:order val="3"/>
          <c:tx>
            <c:strRef>
              <c:f>Genus_excluded!$E$38</c:f>
              <c:strCache>
                <c:ptCount val="1"/>
                <c:pt idx="0">
                  <c:v>1000</c:v>
                </c:pt>
              </c:strCache>
            </c:strRef>
          </c:tx>
          <c:cat>
            <c:strRef>
              <c:f>Genus_excluded!$A$39:$A$49</c:f>
              <c:strCache>
                <c:ptCount val="11"/>
                <c:pt idx="0">
                  <c:v>CARMA3</c:v>
                </c:pt>
                <c:pt idx="1">
                  <c:v>CLARK</c:v>
                </c:pt>
                <c:pt idx="2">
                  <c:v>DiScRIBinATE RAPSearch2</c:v>
                </c:pt>
                <c:pt idx="3">
                  <c:v>Kraken</c:v>
                </c:pt>
                <c:pt idx="4">
                  <c:v>Filtered Kraken</c:v>
                </c:pt>
                <c:pt idx="5">
                  <c:v>MEGAN4 BLASTN</c:v>
                </c:pt>
                <c:pt idx="6">
                  <c:v>MEGAN4 RAPSearch2</c:v>
                </c:pt>
                <c:pt idx="7">
                  <c:v>MetaBin</c:v>
                </c:pt>
                <c:pt idx="8">
                  <c:v>MetaCV</c:v>
                </c:pt>
                <c:pt idx="9">
                  <c:v>MetaPhyler</c:v>
                </c:pt>
                <c:pt idx="10">
                  <c:v>TACOA</c:v>
                </c:pt>
              </c:strCache>
            </c:strRef>
          </c:cat>
          <c:val>
            <c:numRef>
              <c:f>Genus_excluded!$E$39:$E$49</c:f>
              <c:numCache>
                <c:formatCode>General</c:formatCode>
                <c:ptCount val="11"/>
                <c:pt idx="0">
                  <c:v>1.4036059912435399</c:v>
                </c:pt>
                <c:pt idx="1">
                  <c:v>2.0282366520326708E-2</c:v>
                </c:pt>
                <c:pt idx="2">
                  <c:v>1.4973703708245598</c:v>
                </c:pt>
                <c:pt idx="3">
                  <c:v>0.113821834806783</c:v>
                </c:pt>
                <c:pt idx="4">
                  <c:v>1.7496846590132198</c:v>
                </c:pt>
                <c:pt idx="5">
                  <c:v>0.28137664486405312</c:v>
                </c:pt>
                <c:pt idx="6">
                  <c:v>0.9162112355593881</c:v>
                </c:pt>
                <c:pt idx="7">
                  <c:v>1.1599191007860801</c:v>
                </c:pt>
                <c:pt idx="8">
                  <c:v>0.3520622279006641</c:v>
                </c:pt>
                <c:pt idx="9">
                  <c:v>1.1641231201809201</c:v>
                </c:pt>
                <c:pt idx="10">
                  <c:v>3.0783348837710705</c:v>
                </c:pt>
              </c:numCache>
            </c:numRef>
          </c:val>
        </c:ser>
        <c:dLbls/>
        <c:axId val="108687360"/>
        <c:axId val="108688896"/>
      </c:barChart>
      <c:catAx>
        <c:axId val="108687360"/>
        <c:scaling>
          <c:orientation val="minMax"/>
        </c:scaling>
        <c:axPos val="b"/>
        <c:tickLblPos val="nextTo"/>
        <c:txPr>
          <a:bodyPr/>
          <a:lstStyle/>
          <a:p>
            <a:pPr>
              <a:defRPr sz="1050"/>
            </a:pPr>
            <a:endParaRPr lang="en-US"/>
          </a:p>
        </c:txPr>
        <c:crossAx val="108688896"/>
        <c:crosses val="autoZero"/>
        <c:auto val="1"/>
        <c:lblAlgn val="ctr"/>
        <c:lblOffset val="100"/>
      </c:catAx>
      <c:valAx>
        <c:axId val="10868889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50"/>
                </a:pPr>
                <a:r>
                  <a:rPr lang="en-CA" sz="1050"/>
                  <a:t>Taxonomic distance</a:t>
                </a:r>
              </a:p>
            </c:rich>
          </c:tx>
          <c:layout>
            <c:manualLayout>
              <c:xMode val="edge"/>
              <c:yMode val="edge"/>
              <c:x val="2.2460438999489536E-2"/>
              <c:y val="8.6830872531315967E-2"/>
            </c:manualLayout>
          </c:layout>
        </c:title>
        <c:numFmt formatCode="General" sourceLinked="1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08687360"/>
        <c:crosses val="autoZero"/>
        <c:crossBetween val="between"/>
      </c:valAx>
      <c:spPr>
        <a:ln>
          <a:solidFill>
            <a:schemeClr val="tx1"/>
          </a:solidFill>
        </a:ln>
      </c:spPr>
    </c:plotArea>
    <c:legend>
      <c:legendPos val="r"/>
      <c:layout>
        <c:manualLayout>
          <c:xMode val="edge"/>
          <c:yMode val="edge"/>
          <c:x val="0.90528399110907454"/>
          <c:y val="0.18884958677558591"/>
          <c:w val="8.2464860345749291E-2"/>
          <c:h val="0.3776521702613268"/>
        </c:manualLayout>
      </c:layout>
      <c:txPr>
        <a:bodyPr/>
        <a:lstStyle/>
        <a:p>
          <a:pPr>
            <a:defRPr sz="1100"/>
          </a:pPr>
          <a:endParaRPr lang="en-US"/>
        </a:p>
      </c:txPr>
    </c:legend>
    <c:plotVisOnly val="1"/>
    <c:dispBlanksAs val="gap"/>
  </c:chart>
  <c:spPr>
    <a:ln>
      <a:solidFill>
        <a:schemeClr val="bg1"/>
      </a:solidFill>
    </a:ln>
  </c:spPr>
  <c:externalData r:id="rId1"/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3"/>
  <c:chart>
    <c:plotArea>
      <c:layout/>
      <c:barChart>
        <c:barDir val="col"/>
        <c:grouping val="clustered"/>
        <c:ser>
          <c:idx val="0"/>
          <c:order val="0"/>
          <c:tx>
            <c:strRef>
              <c:f>InVitro_Community!$B$3</c:f>
              <c:strCache>
                <c:ptCount val="1"/>
                <c:pt idx="0">
                  <c:v>In silico</c:v>
                </c:pt>
              </c:strCache>
            </c:strRef>
          </c:tx>
          <c:cat>
            <c:strRef>
              <c:f>InVitro_Community!$A$4:$A$15</c:f>
              <c:strCache>
                <c:ptCount val="12"/>
                <c:pt idx="0">
                  <c:v>CARMA3</c:v>
                </c:pt>
                <c:pt idx="1">
                  <c:v>DiScRIBinATE RAPSearch2</c:v>
                </c:pt>
                <c:pt idx="2">
                  <c:v>Kraken</c:v>
                </c:pt>
                <c:pt idx="3">
                  <c:v>Filtered Kraken</c:v>
                </c:pt>
                <c:pt idx="4">
                  <c:v>MEGAN4 BLASTN</c:v>
                </c:pt>
                <c:pt idx="5">
                  <c:v>MEGAN4 RAPSearch2</c:v>
                </c:pt>
                <c:pt idx="6">
                  <c:v>MetaBin</c:v>
                </c:pt>
                <c:pt idx="7">
                  <c:v>MetaCV</c:v>
                </c:pt>
                <c:pt idx="8">
                  <c:v>MetaPhyler</c:v>
                </c:pt>
                <c:pt idx="9">
                  <c:v>PhymmBL</c:v>
                </c:pt>
                <c:pt idx="10">
                  <c:v>RITA</c:v>
                </c:pt>
                <c:pt idx="11">
                  <c:v>TACOA</c:v>
                </c:pt>
              </c:strCache>
            </c:strRef>
          </c:cat>
          <c:val>
            <c:numRef>
              <c:f>InVitro_Community!$B$4:$B$16</c:f>
              <c:numCache>
                <c:formatCode>General</c:formatCode>
                <c:ptCount val="13"/>
                <c:pt idx="0">
                  <c:v>0.92506901892128501</c:v>
                </c:pt>
                <c:pt idx="1">
                  <c:v>0.96197225776041995</c:v>
                </c:pt>
                <c:pt idx="2">
                  <c:v>1</c:v>
                </c:pt>
                <c:pt idx="3">
                  <c:v>1</c:v>
                </c:pt>
                <c:pt idx="4">
                  <c:v>0.99999663322335219</c:v>
                </c:pt>
                <c:pt idx="5">
                  <c:v>0.95461921756110746</c:v>
                </c:pt>
                <c:pt idx="6">
                  <c:v>0.90649114537741582</c:v>
                </c:pt>
                <c:pt idx="7">
                  <c:v>0.96473638138845896</c:v>
                </c:pt>
                <c:pt idx="8">
                  <c:v>3.8212914955221907E-3</c:v>
                </c:pt>
                <c:pt idx="9">
                  <c:v>0.59123964716180699</c:v>
                </c:pt>
                <c:pt idx="10">
                  <c:v>0.48237155747087712</c:v>
                </c:pt>
                <c:pt idx="11">
                  <c:v>0.65087536192849038</c:v>
                </c:pt>
              </c:numCache>
            </c:numRef>
          </c:val>
        </c:ser>
        <c:ser>
          <c:idx val="1"/>
          <c:order val="1"/>
          <c:tx>
            <c:strRef>
              <c:f>InVitro_Community!$C$3</c:f>
              <c:strCache>
                <c:ptCount val="1"/>
                <c:pt idx="0">
                  <c:v>In vitro</c:v>
                </c:pt>
              </c:strCache>
            </c:strRef>
          </c:tx>
          <c:cat>
            <c:strRef>
              <c:f>InVitro_Community!$A$4:$A$15</c:f>
              <c:strCache>
                <c:ptCount val="12"/>
                <c:pt idx="0">
                  <c:v>CARMA3</c:v>
                </c:pt>
                <c:pt idx="1">
                  <c:v>DiScRIBinATE RAPSearch2</c:v>
                </c:pt>
                <c:pt idx="2">
                  <c:v>Kraken</c:v>
                </c:pt>
                <c:pt idx="3">
                  <c:v>Filtered Kraken</c:v>
                </c:pt>
                <c:pt idx="4">
                  <c:v>MEGAN4 BLASTN</c:v>
                </c:pt>
                <c:pt idx="5">
                  <c:v>MEGAN4 RAPSearch2</c:v>
                </c:pt>
                <c:pt idx="6">
                  <c:v>MetaBin</c:v>
                </c:pt>
                <c:pt idx="7">
                  <c:v>MetaCV</c:v>
                </c:pt>
                <c:pt idx="8">
                  <c:v>MetaPhyler</c:v>
                </c:pt>
                <c:pt idx="9">
                  <c:v>PhymmBL</c:v>
                </c:pt>
                <c:pt idx="10">
                  <c:v>RITA</c:v>
                </c:pt>
                <c:pt idx="11">
                  <c:v>TACOA</c:v>
                </c:pt>
              </c:strCache>
            </c:strRef>
          </c:cat>
          <c:val>
            <c:numRef>
              <c:f>InVitro_Community!$C$4:$C$15</c:f>
              <c:numCache>
                <c:formatCode>General</c:formatCode>
                <c:ptCount val="12"/>
                <c:pt idx="0">
                  <c:v>0.85818805259013442</c:v>
                </c:pt>
                <c:pt idx="1">
                  <c:v>0.89016144519867502</c:v>
                </c:pt>
                <c:pt idx="2">
                  <c:v>0.90222581063166019</c:v>
                </c:pt>
                <c:pt idx="3">
                  <c:v>0.90261787758872225</c:v>
                </c:pt>
                <c:pt idx="4">
                  <c:v>0.82439719705351722</c:v>
                </c:pt>
                <c:pt idx="5">
                  <c:v>0.63289242413670521</c:v>
                </c:pt>
                <c:pt idx="6">
                  <c:v>0.78920088115387321</c:v>
                </c:pt>
                <c:pt idx="7">
                  <c:v>0.88376876023776463</c:v>
                </c:pt>
                <c:pt idx="8">
                  <c:v>4.6383514581235918E-3</c:v>
                </c:pt>
                <c:pt idx="9">
                  <c:v>0.73819895072250019</c:v>
                </c:pt>
                <c:pt idx="10">
                  <c:v>0.52034262664925601</c:v>
                </c:pt>
                <c:pt idx="11">
                  <c:v>0.67249450940130095</c:v>
                </c:pt>
              </c:numCache>
            </c:numRef>
          </c:val>
        </c:ser>
        <c:dLbls/>
        <c:axId val="108715008"/>
        <c:axId val="108741376"/>
      </c:barChart>
      <c:catAx>
        <c:axId val="108715008"/>
        <c:scaling>
          <c:orientation val="minMax"/>
        </c:scaling>
        <c:axPos val="b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08741376"/>
        <c:crosses val="autoZero"/>
        <c:auto val="1"/>
        <c:lblAlgn val="ctr"/>
        <c:lblOffset val="100"/>
      </c:catAx>
      <c:valAx>
        <c:axId val="108741376"/>
        <c:scaling>
          <c:orientation val="minMax"/>
          <c:max val="1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Sensitivity</a:t>
                </a:r>
              </a:p>
            </c:rich>
          </c:tx>
          <c:layout/>
        </c:title>
        <c:numFmt formatCode="General" sourceLinked="1"/>
        <c:tickLblPos val="nextTo"/>
        <c:crossAx val="108715008"/>
        <c:crosses val="autoZero"/>
        <c:crossBetween val="between"/>
        <c:majorUnit val="0.2"/>
      </c:valAx>
    </c:plotArea>
    <c:legend>
      <c:legendPos val="r"/>
      <c:layout/>
      <c:txPr>
        <a:bodyPr/>
        <a:lstStyle/>
        <a:p>
          <a:pPr>
            <a:defRPr sz="1100" i="1"/>
          </a:pPr>
          <a:endParaRPr lang="en-US"/>
        </a:p>
      </c:txPr>
    </c:legend>
    <c:plotVisOnly val="1"/>
    <c:dispBlanksAs val="gap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83457</cdr:x>
      <cdr:y>0.03418</cdr:y>
    </cdr:from>
    <cdr:to>
      <cdr:x>1</cdr:x>
      <cdr:y>0.2598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107559" y="98425"/>
          <a:ext cx="1012441" cy="6499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CA" sz="1100" u="sng"/>
            <a:t>Level of clade exclusion</a:t>
          </a: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00776</cdr:x>
      <cdr:y>0.0137</cdr:y>
    </cdr:from>
    <cdr:to>
      <cdr:x>0.07878</cdr:x>
      <cdr:y>0.1075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0800" y="50800"/>
          <a:ext cx="464765" cy="3480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400" b="1"/>
            <a:t>B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8897</cdr:x>
      <cdr:y>0.1061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464377" cy="3194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400" b="1" dirty="0"/>
            <a:t>A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1446</cdr:x>
      <cdr:y>0.1577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626896" cy="47410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400" b="1" dirty="0"/>
            <a:t>B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83457</cdr:x>
      <cdr:y>0.0474</cdr:y>
    </cdr:from>
    <cdr:to>
      <cdr:x>1</cdr:x>
      <cdr:y>0.27307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5107559" y="136525"/>
          <a:ext cx="1012441" cy="6499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CA" sz="1100" u="sng" dirty="0"/>
            <a:t>Read length</a:t>
          </a:r>
        </a:p>
      </cdr:txBody>
    </cdr:sp>
  </cdr:relSizeAnchor>
  <cdr:relSizeAnchor xmlns:cdr="http://schemas.openxmlformats.org/drawingml/2006/chartDrawing">
    <cdr:from>
      <cdr:x>0</cdr:x>
      <cdr:y>0</cdr:y>
    </cdr:from>
    <cdr:to>
      <cdr:x>0.07594</cdr:x>
      <cdr:y>0.12085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0" y="0"/>
          <a:ext cx="464764" cy="3480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400" b="1"/>
            <a:t>A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04</cdr:x>
      <cdr:y>0.179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624465" cy="5165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400" b="1"/>
            <a:t>B</a:t>
          </a:r>
        </a:p>
      </cdr:txBody>
    </cdr:sp>
  </cdr:relSizeAnchor>
  <cdr:relSizeAnchor xmlns:cdr="http://schemas.openxmlformats.org/drawingml/2006/chartDrawing">
    <cdr:from>
      <cdr:x>0.83457</cdr:x>
      <cdr:y>0.05622</cdr:y>
    </cdr:from>
    <cdr:to>
      <cdr:x>1</cdr:x>
      <cdr:y>0.28189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5107559" y="161925"/>
          <a:ext cx="1012441" cy="6499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r"/>
          <a:r>
            <a:rPr lang="en-CA" sz="1100" u="sng"/>
            <a:t>Read length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7044</cdr:x>
      <cdr:y>0.0990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438150" cy="25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400" b="1"/>
            <a:t>C</a:t>
          </a:r>
        </a:p>
      </cdr:txBody>
    </cdr:sp>
  </cdr:relSizeAnchor>
  <cdr:relSizeAnchor xmlns:cdr="http://schemas.openxmlformats.org/drawingml/2006/chartDrawing">
    <cdr:from>
      <cdr:x>0.8928</cdr:x>
      <cdr:y>0.0255</cdr:y>
    </cdr:from>
    <cdr:to>
      <cdr:x>0.99387</cdr:x>
      <cdr:y>0.24796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5553074" y="66179"/>
          <a:ext cx="628651" cy="57741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CA" sz="1100" u="sng"/>
            <a:t>Read</a:t>
          </a:r>
        </a:p>
        <a:p xmlns:a="http://schemas.openxmlformats.org/drawingml/2006/main">
          <a:pPr algn="ctr"/>
          <a:r>
            <a:rPr lang="en-CA" sz="1100" u="sng"/>
            <a:t>length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07587</cdr:x>
      <cdr:y>0.12085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0" y="0"/>
          <a:ext cx="462957" cy="3480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400" b="1"/>
            <a:t>A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10204</cdr:x>
      <cdr:y>0.179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0"/>
          <a:ext cx="624465" cy="5165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400" b="1"/>
            <a:t>B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</cdr:x>
      <cdr:y>0.01175</cdr:y>
    </cdr:from>
    <cdr:to>
      <cdr:x>0.07078</cdr:x>
      <cdr:y>0.0922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50800"/>
          <a:ext cx="464765" cy="3480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CA" sz="1400" b="1"/>
            <a:t>A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914399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157073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398218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3882444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4220361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3432595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436561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37692860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412091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4948565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563471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647AB-699F-44FA-9338-DD29C0AF779C}" type="datetimeFigureOut">
              <a:rPr lang="en-CA" smtClean="0"/>
              <a:pPr/>
              <a:t>22/10/20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2F7AF-7D4D-4147-923A-082896A53C93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4052590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8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/>
          <p:cNvSpPr txBox="1">
            <a:spLocks noChangeArrowheads="1"/>
          </p:cNvSpPr>
          <p:nvPr/>
        </p:nvSpPr>
        <p:spPr bwMode="auto">
          <a:xfrm>
            <a:off x="228600" y="0"/>
            <a:ext cx="640080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</a:rPr>
              <a:t>Additional </a:t>
            </a:r>
            <a:r>
              <a:rPr lang="en-US" sz="1200" b="1" smtClean="0">
                <a:latin typeface="Times New Roman" pitchFamily="18" charset="0"/>
              </a:rPr>
              <a:t>file 2</a:t>
            </a:r>
          </a:p>
          <a:p>
            <a:pPr algn="just">
              <a:lnSpc>
                <a:spcPct val="150000"/>
              </a:lnSpc>
            </a:pPr>
            <a:r>
              <a:rPr lang="en-US" sz="1200" b="1" smtClean="0">
                <a:latin typeface="Times New Roman" pitchFamily="18" charset="0"/>
              </a:rPr>
              <a:t>Figure </a:t>
            </a:r>
            <a:r>
              <a:rPr lang="en-US" sz="1200" b="1" dirty="0" smtClean="0">
                <a:latin typeface="Times New Roman" pitchFamily="18" charset="0"/>
              </a:rPr>
              <a:t>S1</a:t>
            </a:r>
            <a:r>
              <a:rPr lang="en-US" sz="1200" b="1" dirty="0" smtClean="0">
                <a:latin typeface="Times New Roman" pitchFamily="18" charset="0"/>
              </a:rPr>
              <a:t>.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precision with no clade exclusion. Performance of methods on the 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SimHC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set of simulated 250 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ads. The vast majority of methods perform very well when the species being classified are in the database or training set that the methods rely on.</a:t>
            </a:r>
            <a:endParaRPr lang="en-US" sz="1200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369000" y="3073002"/>
          <a:ext cx="6120000" cy="29979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3417691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/>
          <p:cNvSpPr txBox="1">
            <a:spLocks noChangeArrowheads="1"/>
          </p:cNvSpPr>
          <p:nvPr/>
        </p:nvSpPr>
        <p:spPr bwMode="auto">
          <a:xfrm>
            <a:off x="228600" y="0"/>
            <a:ext cx="6400800" cy="1477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</a:rPr>
              <a:t>Figure S2.</a:t>
            </a:r>
            <a:endParaRPr lang="en-US" sz="1200" b="1" dirty="0">
              <a:latin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xonomic distance with no clade exclusion. Taxonomic distance of methods on the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SimHC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set of simulated 250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ads with no clade exclusion. TACOA is very conservative and assigns reads at non-specific taxonomic levels, whereas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cRIBinATE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Phyler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relatively conservative.</a:t>
            </a:r>
            <a:endParaRPr lang="en-US" sz="1200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875040143"/>
              </p:ext>
            </p:extLst>
          </p:nvPr>
        </p:nvGraphicFramePr>
        <p:xfrm>
          <a:off x="148828" y="3109317"/>
          <a:ext cx="6709172" cy="29253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33446898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/>
          <p:cNvSpPr txBox="1">
            <a:spLocks noChangeArrowheads="1"/>
          </p:cNvSpPr>
          <p:nvPr/>
        </p:nvSpPr>
        <p:spPr bwMode="auto">
          <a:xfrm>
            <a:off x="228600" y="0"/>
            <a:ext cx="6400800" cy="1477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</a:rPr>
              <a:t>Figure S3.</a:t>
            </a:r>
            <a:endParaRPr lang="en-US" sz="1200" b="1" dirty="0">
              <a:latin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xonomic distance with varying levels of clade exclusion. Taxonomic distance of methods on the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SimHC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set of simulated 250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ads with various level of clade exclusion. Methods show a general decrease in taxonomic distance as clade exclusion level is increased, as there are less ranks above the best possible rank at which to classify.</a:t>
            </a:r>
            <a:endParaRPr lang="en-US" sz="1200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4"/>
          <p:cNvGraphicFramePr>
            <a:graphicFrameLocks/>
          </p:cNvGraphicFramePr>
          <p:nvPr/>
        </p:nvGraphicFramePr>
        <p:xfrm>
          <a:off x="369000" y="3132000"/>
          <a:ext cx="61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33446898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/>
          <p:cNvSpPr txBox="1">
            <a:spLocks noChangeArrowheads="1"/>
          </p:cNvSpPr>
          <p:nvPr/>
        </p:nvSpPr>
        <p:spPr bwMode="auto">
          <a:xfrm>
            <a:off x="228600" y="0"/>
            <a:ext cx="6400800" cy="9233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  <a:cs typeface="Times New Roman" panose="02020603050405020304" pitchFamily="18" charset="0"/>
              </a:rPr>
              <a:t>Figure S4.</a:t>
            </a:r>
            <a:endParaRPr lang="en-US" sz="1200" b="1" dirty="0">
              <a:latin typeface="Times New Roman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s of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sassigned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correct/overpredicted assignments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each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xonomic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nk on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SimHC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set of simulated 250 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ads under genus clade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.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4277532414"/>
              </p:ext>
            </p:extLst>
          </p:nvPr>
        </p:nvGraphicFramePr>
        <p:xfrm>
          <a:off x="332656" y="1477328"/>
          <a:ext cx="5976664" cy="33106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818696503"/>
              </p:ext>
            </p:extLst>
          </p:nvPr>
        </p:nvGraphicFramePr>
        <p:xfrm>
          <a:off x="260648" y="4788024"/>
          <a:ext cx="5976664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xmlns="" val="16277931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/>
          <p:cNvSpPr txBox="1">
            <a:spLocks noChangeArrowheads="1"/>
          </p:cNvSpPr>
          <p:nvPr/>
        </p:nvSpPr>
        <p:spPr bwMode="auto">
          <a:xfrm>
            <a:off x="228600" y="0"/>
            <a:ext cx="6400800" cy="1477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  <a:cs typeface="Times New Roman" panose="02020603050405020304" pitchFamily="18" charset="0"/>
              </a:rPr>
              <a:t>Figure S5.</a:t>
            </a:r>
            <a:endParaRPr lang="en-US" sz="1200" b="1" dirty="0">
              <a:latin typeface="Times New Roman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formance as read length is varied. Sensitivity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precision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and taxonomic distance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methods on the </a:t>
            </a:r>
            <a:r>
              <a:rPr lang="en-CA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aSimHC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set simulated at lengths of 100, 250, 500, and 1000 bases with genera clade exclusion. The sensitivity of the methods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nds to increase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increasing read length whereas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cision and taxonomic distance do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 seem to change substantially.</a:t>
            </a:r>
            <a:endParaRPr lang="en-US" sz="1200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624322282"/>
              </p:ext>
            </p:extLst>
          </p:nvPr>
        </p:nvGraphicFramePr>
        <p:xfrm>
          <a:off x="222845" y="1477329"/>
          <a:ext cx="6014467" cy="25186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889490763"/>
              </p:ext>
            </p:extLst>
          </p:nvPr>
        </p:nvGraphicFramePr>
        <p:xfrm>
          <a:off x="255612" y="3923928"/>
          <a:ext cx="6080720" cy="25922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275100360"/>
              </p:ext>
            </p:extLst>
          </p:nvPr>
        </p:nvGraphicFramePr>
        <p:xfrm>
          <a:off x="116632" y="6372200"/>
          <a:ext cx="6219825" cy="25955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xmlns="" val="33446898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/>
          <p:cNvSpPr txBox="1">
            <a:spLocks noChangeArrowheads="1"/>
          </p:cNvSpPr>
          <p:nvPr/>
        </p:nvSpPr>
        <p:spPr bwMode="auto">
          <a:xfrm>
            <a:off x="228600" y="0"/>
            <a:ext cx="640080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  <a:cs typeface="Times New Roman" panose="02020603050405020304" pitchFamily="18" charset="0"/>
              </a:rPr>
              <a:t>Figure S6.</a:t>
            </a:r>
            <a:endParaRPr lang="en-US" sz="1200" b="1" dirty="0">
              <a:latin typeface="Times New Roman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formance of FW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ilico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rsus FW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CA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tro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out clade exclusion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recision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methods on the FW dataset comparing the performance on the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CA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lico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munity versus the </a:t>
            </a:r>
            <a:r>
              <a:rPr lang="en-CA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munity.</a:t>
            </a: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851220090"/>
              </p:ext>
            </p:extLst>
          </p:nvPr>
        </p:nvGraphicFramePr>
        <p:xfrm>
          <a:off x="369000" y="2051720"/>
          <a:ext cx="61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882196813"/>
              </p:ext>
            </p:extLst>
          </p:nvPr>
        </p:nvGraphicFramePr>
        <p:xfrm>
          <a:off x="369000" y="5076056"/>
          <a:ext cx="61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xmlns="" val="35575719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/>
          <p:cNvSpPr txBox="1">
            <a:spLocks noChangeArrowheads="1"/>
          </p:cNvSpPr>
          <p:nvPr/>
        </p:nvSpPr>
        <p:spPr bwMode="auto">
          <a:xfrm>
            <a:off x="228600" y="0"/>
            <a:ext cx="6400800" cy="17543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</a:rPr>
              <a:t>Figure S7.</a:t>
            </a:r>
            <a:endParaRPr lang="en-US" sz="1200" b="1" dirty="0">
              <a:latin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running time. Running time for the various methods was calculated on a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SimHC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taset of 22,000 simulated reads of various read lengths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or 22,000 and 44,000 reads of 250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CA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similarity </a:t>
            </a:r>
            <a:r>
              <a:rPr lang="en-CA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arch programs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kes up the majority of time to run for the methods that rely </a:t>
            </a:r>
            <a:r>
              <a:rPr lang="en-CA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them, 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 these methods overlap on the graphs (e.g. MEGAN4 and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cRIBinATE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LASTX, CARMA3, and </a:t>
            </a:r>
            <a:r>
              <a:rPr lang="en-CA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aBin</a:t>
            </a:r>
            <a:r>
              <a:rPr lang="en-CA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ll use BLASTX).</a:t>
            </a:r>
            <a:endParaRPr lang="en-US" sz="1200" dirty="0">
              <a:latin typeface="Times New Roman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602385215"/>
              </p:ext>
            </p:extLst>
          </p:nvPr>
        </p:nvGraphicFramePr>
        <p:xfrm>
          <a:off x="228600" y="1754326"/>
          <a:ext cx="6296744" cy="38257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858982875"/>
              </p:ext>
            </p:extLst>
          </p:nvPr>
        </p:nvGraphicFramePr>
        <p:xfrm>
          <a:off x="228600" y="5652120"/>
          <a:ext cx="6286743" cy="331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xmlns="" val="2400887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1</TotalTime>
  <Words>453</Words>
  <Application>Microsoft Office PowerPoint</Application>
  <PresentationFormat>On-screen Show (4:3)</PresentationFormat>
  <Paragraphs>40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e</dc:creator>
  <cp:lastModifiedBy>Ljabar</cp:lastModifiedBy>
  <cp:revision>20</cp:revision>
  <dcterms:created xsi:type="dcterms:W3CDTF">2015-06-26T11:27:50Z</dcterms:created>
  <dcterms:modified xsi:type="dcterms:W3CDTF">2015-10-21T16:25:25Z</dcterms:modified>
</cp:coreProperties>
</file>